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9" r:id="rId3"/>
    <p:sldId id="265" r:id="rId4"/>
    <p:sldId id="266" r:id="rId5"/>
    <p:sldId id="258" r:id="rId6"/>
    <p:sldId id="261" r:id="rId7"/>
    <p:sldId id="262" r:id="rId8"/>
    <p:sldId id="263" r:id="rId9"/>
    <p:sldId id="260" r:id="rId10"/>
    <p:sldId id="269" r:id="rId11"/>
    <p:sldId id="270" r:id="rId12"/>
    <p:sldId id="272" r:id="rId13"/>
    <p:sldId id="276" r:id="rId14"/>
    <p:sldId id="274" r:id="rId15"/>
    <p:sldId id="275" r:id="rId1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2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43" autoAdjust="0"/>
    <p:restoredTop sz="94660"/>
  </p:normalViewPr>
  <p:slideViewPr>
    <p:cSldViewPr snapToGrid="0" showGuides="1">
      <p:cViewPr>
        <p:scale>
          <a:sx n="100" d="100"/>
          <a:sy n="100" d="100"/>
        </p:scale>
        <p:origin x="882" y="420"/>
      </p:cViewPr>
      <p:guideLst>
        <p:guide orient="horz" pos="192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A7694-28CB-4632-87E0-FA720E3725DB}" type="datetimeFigureOut">
              <a:rPr lang="en-US" smtClean="0"/>
              <a:t>5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F74A3-7E3D-43C7-96D6-5CF3B6D96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8805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A7694-28CB-4632-87E0-FA720E3725DB}" type="datetimeFigureOut">
              <a:rPr lang="en-US" smtClean="0"/>
              <a:t>5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F74A3-7E3D-43C7-96D6-5CF3B6D96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06495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A7694-28CB-4632-87E0-FA720E3725DB}" type="datetimeFigureOut">
              <a:rPr lang="en-US" smtClean="0"/>
              <a:t>5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F74A3-7E3D-43C7-96D6-5CF3B6D96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9909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A7694-28CB-4632-87E0-FA720E3725DB}" type="datetimeFigureOut">
              <a:rPr lang="en-US" smtClean="0"/>
              <a:t>5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F74A3-7E3D-43C7-96D6-5CF3B6D96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60237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A7694-28CB-4632-87E0-FA720E3725DB}" type="datetimeFigureOut">
              <a:rPr lang="en-US" smtClean="0"/>
              <a:t>5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F74A3-7E3D-43C7-96D6-5CF3B6D96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76100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A7694-28CB-4632-87E0-FA720E3725DB}" type="datetimeFigureOut">
              <a:rPr lang="en-US" smtClean="0"/>
              <a:t>5/1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F74A3-7E3D-43C7-96D6-5CF3B6D96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34332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A7694-28CB-4632-87E0-FA720E3725DB}" type="datetimeFigureOut">
              <a:rPr lang="en-US" smtClean="0"/>
              <a:t>5/1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F74A3-7E3D-43C7-96D6-5CF3B6D96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41015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A7694-28CB-4632-87E0-FA720E3725DB}" type="datetimeFigureOut">
              <a:rPr lang="en-US" smtClean="0"/>
              <a:t>5/1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F74A3-7E3D-43C7-96D6-5CF3B6D96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3510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A7694-28CB-4632-87E0-FA720E3725DB}" type="datetimeFigureOut">
              <a:rPr lang="en-US" smtClean="0"/>
              <a:t>5/1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F74A3-7E3D-43C7-96D6-5CF3B6D96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44915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A7694-28CB-4632-87E0-FA720E3725DB}" type="datetimeFigureOut">
              <a:rPr lang="en-US" smtClean="0"/>
              <a:t>5/1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F74A3-7E3D-43C7-96D6-5CF3B6D96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03732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A7694-28CB-4632-87E0-FA720E3725DB}" type="datetimeFigureOut">
              <a:rPr lang="en-US" smtClean="0"/>
              <a:t>5/1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F74A3-7E3D-43C7-96D6-5CF3B6D96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623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7A7694-28CB-4632-87E0-FA720E3725DB}" type="datetimeFigureOut">
              <a:rPr lang="en-US" smtClean="0"/>
              <a:t>5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2F74A3-7E3D-43C7-96D6-5CF3B6D96A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27109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841" y="272717"/>
            <a:ext cx="12192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 smtClean="0"/>
              <a:t>Western Blot Analysis of EV Extracts for conventional and Signaling markers</a:t>
            </a:r>
            <a:endParaRPr lang="en-US" sz="2400" b="1" dirty="0"/>
          </a:p>
        </p:txBody>
      </p:sp>
      <p:grpSp>
        <p:nvGrpSpPr>
          <p:cNvPr id="3" name="Group 2"/>
          <p:cNvGrpSpPr/>
          <p:nvPr/>
        </p:nvGrpSpPr>
        <p:grpSpPr>
          <a:xfrm>
            <a:off x="6501403" y="1489452"/>
            <a:ext cx="3775322" cy="2867779"/>
            <a:chOff x="1291350" y="1456816"/>
            <a:chExt cx="3775322" cy="2867779"/>
          </a:xfrm>
        </p:grpSpPr>
        <p:sp>
          <p:nvSpPr>
            <p:cNvPr id="44" name="TextBox 43"/>
            <p:cNvSpPr txBox="1"/>
            <p:nvPr/>
          </p:nvSpPr>
          <p:spPr>
            <a:xfrm>
              <a:off x="3949378" y="2455629"/>
              <a:ext cx="111729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WB: Pan </a:t>
              </a:r>
              <a:r>
                <a:rPr lang="en-US" sz="1400" b="1" dirty="0" err="1" smtClean="0"/>
                <a:t>Ras</a:t>
              </a:r>
              <a:endParaRPr lang="en-US" sz="1400" b="1" dirty="0"/>
            </a:p>
          </p:txBody>
        </p:sp>
        <p:grpSp>
          <p:nvGrpSpPr>
            <p:cNvPr id="2" name="Group 1"/>
            <p:cNvGrpSpPr/>
            <p:nvPr/>
          </p:nvGrpSpPr>
          <p:grpSpPr>
            <a:xfrm>
              <a:off x="1291350" y="1456816"/>
              <a:ext cx="3661829" cy="2867779"/>
              <a:chOff x="1291350" y="1456816"/>
              <a:chExt cx="3661829" cy="2867779"/>
            </a:xfrm>
          </p:grpSpPr>
          <p:sp>
            <p:nvSpPr>
              <p:cNvPr id="15" name="TextBox 14"/>
              <p:cNvSpPr txBox="1"/>
              <p:nvPr/>
            </p:nvSpPr>
            <p:spPr>
              <a:xfrm>
                <a:off x="1291350" y="1456816"/>
                <a:ext cx="230704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/>
                  <a:t>CM61     CF49     HM59</a:t>
                </a:r>
                <a:endParaRPr lang="en-US" b="1" dirty="0"/>
              </a:p>
            </p:txBody>
          </p:sp>
          <p:grpSp>
            <p:nvGrpSpPr>
              <p:cNvPr id="40" name="Group 39"/>
              <p:cNvGrpSpPr/>
              <p:nvPr/>
            </p:nvGrpSpPr>
            <p:grpSpPr>
              <a:xfrm>
                <a:off x="1294963" y="1675179"/>
                <a:ext cx="2617836" cy="1176173"/>
                <a:chOff x="755837" y="3429000"/>
                <a:chExt cx="2617836" cy="1176173"/>
              </a:xfrm>
            </p:grpSpPr>
            <p:pic>
              <p:nvPicPr>
                <p:cNvPr id="5" name="Picture 4"/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3392" t="50636" r="30416" b="32005"/>
                <a:stretch/>
              </p:blipFill>
              <p:spPr>
                <a:xfrm rot="5400000">
                  <a:off x="1371212" y="2940628"/>
                  <a:ext cx="976745" cy="2190562"/>
                </a:xfrm>
                <a:prstGeom prst="rect">
                  <a:avLst/>
                </a:prstGeom>
              </p:spPr>
            </p:pic>
            <p:sp>
              <p:nvSpPr>
                <p:cNvPr id="20" name="TextBox 19"/>
                <p:cNvSpPr txBox="1"/>
                <p:nvPr/>
              </p:nvSpPr>
              <p:spPr>
                <a:xfrm>
                  <a:off x="2884437" y="4235841"/>
                  <a:ext cx="489236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 smtClean="0"/>
                    <a:t>-15</a:t>
                  </a:r>
                  <a:endParaRPr lang="en-US" dirty="0"/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2884437" y="3834405"/>
                  <a:ext cx="489236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 smtClean="0"/>
                    <a:t>-25</a:t>
                  </a:r>
                  <a:endParaRPr lang="en-US" dirty="0"/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>
                  <a:off x="2884437" y="3429000"/>
                  <a:ext cx="489236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 smtClean="0"/>
                    <a:t>-35</a:t>
                  </a:r>
                  <a:endParaRPr lang="en-US" dirty="0"/>
                </a:p>
              </p:txBody>
            </p:sp>
            <p:sp>
              <p:nvSpPr>
                <p:cNvPr id="28" name="Rectangle 27"/>
                <p:cNvSpPr/>
                <p:nvPr/>
              </p:nvSpPr>
              <p:spPr>
                <a:xfrm>
                  <a:off x="755837" y="3550562"/>
                  <a:ext cx="2215963" cy="970886"/>
                </a:xfrm>
                <a:prstGeom prst="rect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39" name="Group 38"/>
              <p:cNvGrpSpPr/>
              <p:nvPr/>
            </p:nvGrpSpPr>
            <p:grpSpPr>
              <a:xfrm>
                <a:off x="1294963" y="3122966"/>
                <a:ext cx="2733627" cy="984021"/>
                <a:chOff x="776435" y="4656149"/>
                <a:chExt cx="2733627" cy="984021"/>
              </a:xfrm>
            </p:grpSpPr>
            <p:grpSp>
              <p:nvGrpSpPr>
                <p:cNvPr id="38" name="Group 37"/>
                <p:cNvGrpSpPr/>
                <p:nvPr/>
              </p:nvGrpSpPr>
              <p:grpSpPr>
                <a:xfrm>
                  <a:off x="2903806" y="4795689"/>
                  <a:ext cx="606256" cy="697470"/>
                  <a:chOff x="3428743" y="4795689"/>
                  <a:chExt cx="606256" cy="697470"/>
                </a:xfrm>
              </p:grpSpPr>
              <p:sp>
                <p:nvSpPr>
                  <p:cNvPr id="23" name="TextBox 22"/>
                  <p:cNvSpPr txBox="1"/>
                  <p:nvPr/>
                </p:nvSpPr>
                <p:spPr>
                  <a:xfrm>
                    <a:off x="3439343" y="5123827"/>
                    <a:ext cx="48923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 smtClean="0"/>
                      <a:t>-70</a:t>
                    </a:r>
                    <a:endParaRPr lang="en-US" dirty="0"/>
                  </a:p>
                </p:txBody>
              </p:sp>
              <p:sp>
                <p:nvSpPr>
                  <p:cNvPr id="24" name="TextBox 23"/>
                  <p:cNvSpPr txBox="1"/>
                  <p:nvPr/>
                </p:nvSpPr>
                <p:spPr>
                  <a:xfrm>
                    <a:off x="3428743" y="4795689"/>
                    <a:ext cx="60625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 smtClean="0"/>
                      <a:t>-100</a:t>
                    </a:r>
                    <a:endParaRPr lang="en-US" dirty="0"/>
                  </a:p>
                </p:txBody>
              </p:sp>
            </p:grpSp>
            <p:grpSp>
              <p:nvGrpSpPr>
                <p:cNvPr id="34" name="Group 33"/>
                <p:cNvGrpSpPr/>
                <p:nvPr/>
              </p:nvGrpSpPr>
              <p:grpSpPr>
                <a:xfrm>
                  <a:off x="776435" y="4656149"/>
                  <a:ext cx="2222599" cy="984021"/>
                  <a:chOff x="776435" y="4656149"/>
                  <a:chExt cx="2222599" cy="984021"/>
                </a:xfrm>
              </p:grpSpPr>
              <p:pic>
                <p:nvPicPr>
                  <p:cNvPr id="4" name="Picture 3"/>
                  <p:cNvPicPr>
                    <a:picLocks noChangeAspect="1"/>
                  </p:cNvPicPr>
                  <p:nvPr/>
                </p:nvPicPr>
                <p:blipFill rotWithShape="1">
                  <a:blip r:embed="rId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80598" t="49133" r="13133" b="33239"/>
                  <a:stretch/>
                </p:blipFill>
                <p:spPr>
                  <a:xfrm rot="5400000">
                    <a:off x="1390834" y="4042272"/>
                    <a:ext cx="983499" cy="2212297"/>
                  </a:xfrm>
                  <a:prstGeom prst="rect">
                    <a:avLst/>
                  </a:prstGeom>
                </p:spPr>
              </p:pic>
              <p:sp>
                <p:nvSpPr>
                  <p:cNvPr id="29" name="Rectangle 28"/>
                  <p:cNvSpPr/>
                  <p:nvPr/>
                </p:nvSpPr>
                <p:spPr>
                  <a:xfrm>
                    <a:off x="783071" y="4656149"/>
                    <a:ext cx="2215963" cy="970886"/>
                  </a:xfrm>
                  <a:prstGeom prst="rect">
                    <a:avLst/>
                  </a:prstGeom>
                  <a:noFill/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sp>
            <p:nvSpPr>
              <p:cNvPr id="45" name="TextBox 44"/>
              <p:cNvSpPr txBox="1"/>
              <p:nvPr/>
            </p:nvSpPr>
            <p:spPr>
              <a:xfrm>
                <a:off x="3949378" y="3772270"/>
                <a:ext cx="100380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/>
                  <a:t>WB: Hsp70</a:t>
                </a:r>
                <a:endParaRPr lang="en-US" sz="1400" b="1" dirty="0"/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1329701" y="2776827"/>
                <a:ext cx="217755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/>
                  <a:t>2244.548: 8974.326: 12369.276</a:t>
                </a:r>
                <a:endParaRPr lang="en-US" sz="1200" b="1" dirty="0"/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1309785" y="4047596"/>
                <a:ext cx="227017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/>
                  <a:t>4443.397: 10135.083: 20673.823</a:t>
                </a:r>
                <a:endParaRPr lang="en-US" sz="1200" b="1" dirty="0"/>
              </a:p>
            </p:txBody>
          </p:sp>
        </p:grpSp>
      </p:grpSp>
      <p:grpSp>
        <p:nvGrpSpPr>
          <p:cNvPr id="41" name="Group 40"/>
          <p:cNvGrpSpPr/>
          <p:nvPr/>
        </p:nvGrpSpPr>
        <p:grpSpPr>
          <a:xfrm>
            <a:off x="3615666" y="4285593"/>
            <a:ext cx="2748130" cy="976768"/>
            <a:chOff x="776436" y="2338982"/>
            <a:chExt cx="2748130" cy="976768"/>
          </a:xfrm>
        </p:grpSpPr>
        <p:grpSp>
          <p:nvGrpSpPr>
            <p:cNvPr id="36" name="Group 35"/>
            <p:cNvGrpSpPr/>
            <p:nvPr/>
          </p:nvGrpSpPr>
          <p:grpSpPr>
            <a:xfrm>
              <a:off x="2918310" y="2401260"/>
              <a:ext cx="606256" cy="863905"/>
              <a:chOff x="3790381" y="2401260"/>
              <a:chExt cx="606256" cy="863905"/>
            </a:xfrm>
          </p:grpSpPr>
          <p:sp>
            <p:nvSpPr>
              <p:cNvPr id="16" name="TextBox 15"/>
              <p:cNvSpPr txBox="1"/>
              <p:nvPr/>
            </p:nvSpPr>
            <p:spPr>
              <a:xfrm>
                <a:off x="3790381" y="2895833"/>
                <a:ext cx="60625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-100</a:t>
                </a:r>
                <a:endParaRPr lang="en-US" dirty="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3790381" y="2401260"/>
                <a:ext cx="60625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-140</a:t>
                </a:r>
                <a:endParaRPr lang="en-US" dirty="0"/>
              </a:p>
            </p:txBody>
          </p:sp>
        </p:grpSp>
        <p:grpSp>
          <p:nvGrpSpPr>
            <p:cNvPr id="31" name="Group 30"/>
            <p:cNvGrpSpPr/>
            <p:nvPr/>
          </p:nvGrpSpPr>
          <p:grpSpPr>
            <a:xfrm>
              <a:off x="776436" y="2338982"/>
              <a:ext cx="2229231" cy="976768"/>
              <a:chOff x="776436" y="2338982"/>
              <a:chExt cx="2229231" cy="976768"/>
            </a:xfrm>
          </p:grpSpPr>
          <p:pic>
            <p:nvPicPr>
              <p:cNvPr id="6" name="Picture 5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883" t="50359" r="44214" b="32672"/>
              <a:stretch/>
            </p:blipFill>
            <p:spPr>
              <a:xfrm rot="5400000">
                <a:off x="1401575" y="1728594"/>
                <a:ext cx="962017" cy="2212295"/>
              </a:xfrm>
              <a:prstGeom prst="rect">
                <a:avLst/>
              </a:prstGeom>
            </p:spPr>
          </p:pic>
          <p:sp>
            <p:nvSpPr>
              <p:cNvPr id="27" name="Rectangle 26"/>
              <p:cNvSpPr/>
              <p:nvPr/>
            </p:nvSpPr>
            <p:spPr>
              <a:xfrm>
                <a:off x="789704" y="2338982"/>
                <a:ext cx="2215963" cy="970886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9" name="Group 8"/>
          <p:cNvGrpSpPr/>
          <p:nvPr/>
        </p:nvGrpSpPr>
        <p:grpSpPr>
          <a:xfrm>
            <a:off x="2269581" y="1489452"/>
            <a:ext cx="3987027" cy="4044026"/>
            <a:chOff x="3746409" y="508992"/>
            <a:chExt cx="3987027" cy="4044026"/>
          </a:xfrm>
        </p:grpSpPr>
        <p:grpSp>
          <p:nvGrpSpPr>
            <p:cNvPr id="35" name="Group 34"/>
            <p:cNvGrpSpPr/>
            <p:nvPr/>
          </p:nvGrpSpPr>
          <p:grpSpPr>
            <a:xfrm>
              <a:off x="7226813" y="2006061"/>
              <a:ext cx="489236" cy="1000985"/>
              <a:chOff x="3545763" y="1080007"/>
              <a:chExt cx="489236" cy="1000985"/>
            </a:xfrm>
          </p:grpSpPr>
          <p:sp>
            <p:nvSpPr>
              <p:cNvPr id="13" name="TextBox 12"/>
              <p:cNvSpPr txBox="1"/>
              <p:nvPr/>
            </p:nvSpPr>
            <p:spPr>
              <a:xfrm>
                <a:off x="3545763" y="1080007"/>
                <a:ext cx="48923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-15</a:t>
                </a:r>
                <a:endParaRPr lang="en-US" dirty="0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3545763" y="1711660"/>
                <a:ext cx="48923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-10</a:t>
                </a:r>
                <a:endParaRPr lang="en-US" dirty="0"/>
              </a:p>
            </p:txBody>
          </p:sp>
        </p:grpSp>
        <p:grpSp>
          <p:nvGrpSpPr>
            <p:cNvPr id="30" name="Group 29"/>
            <p:cNvGrpSpPr/>
            <p:nvPr/>
          </p:nvGrpSpPr>
          <p:grpSpPr>
            <a:xfrm>
              <a:off x="5092494" y="2036160"/>
              <a:ext cx="2229227" cy="978308"/>
              <a:chOff x="776440" y="1110106"/>
              <a:chExt cx="2229227" cy="978308"/>
            </a:xfrm>
          </p:grpSpPr>
          <p:pic>
            <p:nvPicPr>
              <p:cNvPr id="7" name="Picture 6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6515" t="8102" r="59793" b="84387"/>
              <a:stretch/>
            </p:blipFill>
            <p:spPr>
              <a:xfrm>
                <a:off x="776440" y="1110106"/>
                <a:ext cx="2229227" cy="978308"/>
              </a:xfrm>
              <a:prstGeom prst="rect">
                <a:avLst/>
              </a:prstGeom>
            </p:spPr>
          </p:pic>
          <p:sp>
            <p:nvSpPr>
              <p:cNvPr id="26" name="Rectangle 25"/>
              <p:cNvSpPr/>
              <p:nvPr/>
            </p:nvSpPr>
            <p:spPr>
              <a:xfrm>
                <a:off x="789704" y="1110106"/>
                <a:ext cx="2215963" cy="970886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8" name="TextBox 7"/>
            <p:cNvSpPr txBox="1"/>
            <p:nvPr/>
          </p:nvSpPr>
          <p:spPr>
            <a:xfrm>
              <a:off x="3746409" y="2700053"/>
              <a:ext cx="135594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WB: Histone H3</a:t>
              </a:r>
              <a:endParaRPr lang="en-US" sz="1400" b="1" dirty="0"/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4209934" y="3963768"/>
              <a:ext cx="8924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WB: JAK2</a:t>
              </a:r>
              <a:endParaRPr lang="en-US" sz="1400" b="1" dirty="0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5088106" y="2979367"/>
              <a:ext cx="22034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1690.326: 15208.924:5003.882</a:t>
              </a:r>
              <a:endParaRPr lang="en-US" sz="1200" b="1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5117926" y="4276019"/>
              <a:ext cx="21735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979.648: 5609.861:7555.589</a:t>
              </a:r>
              <a:endParaRPr lang="en-US" sz="1200" b="1" dirty="0"/>
            </a:p>
          </p:txBody>
        </p:sp>
        <p:pic>
          <p:nvPicPr>
            <p:cNvPr id="46" name="Picture 45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616" t="47136" r="19720" b="15911"/>
            <a:stretch/>
          </p:blipFill>
          <p:spPr>
            <a:xfrm>
              <a:off x="5075921" y="807941"/>
              <a:ext cx="2211185" cy="980902"/>
            </a:xfrm>
            <a:prstGeom prst="rect">
              <a:avLst/>
            </a:prstGeom>
          </p:spPr>
        </p:pic>
        <p:sp>
          <p:nvSpPr>
            <p:cNvPr id="53" name="Rectangle 52"/>
            <p:cNvSpPr/>
            <p:nvPr/>
          </p:nvSpPr>
          <p:spPr>
            <a:xfrm>
              <a:off x="5079938" y="817834"/>
              <a:ext cx="2215963" cy="97088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5034398" y="508992"/>
              <a:ext cx="23070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CM61     CF49     HM59</a:t>
              </a:r>
              <a:endParaRPr lang="en-US" b="1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5075921" y="1788720"/>
              <a:ext cx="230704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7561.861:  7319.468:  7433.033</a:t>
              </a:r>
              <a:endParaRPr lang="en-US" sz="1200" b="1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7244200" y="1215212"/>
              <a:ext cx="48923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-25</a:t>
              </a:r>
              <a:endParaRPr lang="en-US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7244200" y="1584544"/>
              <a:ext cx="48923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-15</a:t>
              </a:r>
              <a:endParaRPr lang="en-US" dirty="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7229781" y="735042"/>
              <a:ext cx="48923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-35</a:t>
              </a:r>
              <a:endParaRPr lang="en-US" dirty="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4240807" y="1482282"/>
              <a:ext cx="83869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WB: CD9</a:t>
              </a:r>
              <a:endParaRPr lang="en-US" sz="14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78396649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0" y="216131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/>
              <a:t>Unaltered Western Blot for Secreted Fibronectin from Neutrophils treated with CM61 and HM59 EVs (Supernatant)</a:t>
            </a:r>
            <a:endParaRPr lang="en-US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9952809" y="4207889"/>
            <a:ext cx="10855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WB: GAPDH</a:t>
            </a:r>
            <a:endParaRPr lang="en-US" sz="14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5990056" y="3614888"/>
            <a:ext cx="13847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WB: Fibronectin</a:t>
            </a:r>
            <a:endParaRPr lang="en-US" sz="1400" b="1" dirty="0"/>
          </a:p>
        </p:txBody>
      </p:sp>
      <p:grpSp>
        <p:nvGrpSpPr>
          <p:cNvPr id="78" name="Group 77"/>
          <p:cNvGrpSpPr/>
          <p:nvPr/>
        </p:nvGrpSpPr>
        <p:grpSpPr>
          <a:xfrm>
            <a:off x="579426" y="706066"/>
            <a:ext cx="3958299" cy="732248"/>
            <a:chOff x="579426" y="827169"/>
            <a:chExt cx="3958299" cy="732248"/>
          </a:xfrm>
        </p:grpSpPr>
        <p:sp>
          <p:nvSpPr>
            <p:cNvPr id="18" name="TextBox 17"/>
            <p:cNvSpPr txBox="1"/>
            <p:nvPr/>
          </p:nvSpPr>
          <p:spPr>
            <a:xfrm>
              <a:off x="695804" y="1251640"/>
              <a:ext cx="18918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2’         10’      30’      60’</a:t>
              </a:r>
              <a:endParaRPr lang="en-US" sz="1400" b="1" dirty="0"/>
            </a:p>
          </p:txBody>
        </p:sp>
        <p:cxnSp>
          <p:nvCxnSpPr>
            <p:cNvPr id="20" name="Straight Connector 19"/>
            <p:cNvCxnSpPr/>
            <p:nvPr/>
          </p:nvCxnSpPr>
          <p:spPr>
            <a:xfrm>
              <a:off x="670867" y="1193821"/>
              <a:ext cx="1767884" cy="583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/>
            <p:cNvSpPr txBox="1"/>
            <p:nvPr/>
          </p:nvSpPr>
          <p:spPr>
            <a:xfrm>
              <a:off x="579426" y="832593"/>
              <a:ext cx="19388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Neutrophils + CM61 EVs</a:t>
              </a:r>
              <a:endParaRPr lang="en-US" sz="1400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555170" y="827169"/>
              <a:ext cx="195483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Neutrophils + HM59 EVs</a:t>
              </a:r>
              <a:endParaRPr lang="en-US" sz="1400" dirty="0"/>
            </a:p>
          </p:txBody>
        </p:sp>
        <p:cxnSp>
          <p:nvCxnSpPr>
            <p:cNvPr id="30" name="Straight Connector 29"/>
            <p:cNvCxnSpPr/>
            <p:nvPr/>
          </p:nvCxnSpPr>
          <p:spPr>
            <a:xfrm>
              <a:off x="2663193" y="1193821"/>
              <a:ext cx="1767884" cy="583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/>
            <p:cNvSpPr txBox="1"/>
            <p:nvPr/>
          </p:nvSpPr>
          <p:spPr>
            <a:xfrm>
              <a:off x="2645860" y="1246216"/>
              <a:ext cx="18918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2’         10’      30’      60’</a:t>
              </a:r>
              <a:endParaRPr lang="en-US" sz="1400" b="1" dirty="0"/>
            </a:p>
          </p:txBody>
        </p:sp>
      </p:grpSp>
      <p:grpSp>
        <p:nvGrpSpPr>
          <p:cNvPr id="86" name="Group 85"/>
          <p:cNvGrpSpPr/>
          <p:nvPr/>
        </p:nvGrpSpPr>
        <p:grpSpPr>
          <a:xfrm>
            <a:off x="191194" y="1384822"/>
            <a:ext cx="5269502" cy="2774037"/>
            <a:chOff x="191194" y="1363854"/>
            <a:chExt cx="5269502" cy="2774037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37" t="-1" r="3382" b="99"/>
            <a:stretch/>
          </p:blipFill>
          <p:spPr>
            <a:xfrm>
              <a:off x="191194" y="1363854"/>
              <a:ext cx="4832742" cy="2774037"/>
            </a:xfrm>
            <a:prstGeom prst="rect">
              <a:avLst/>
            </a:prstGeom>
          </p:spPr>
        </p:pic>
        <p:grpSp>
          <p:nvGrpSpPr>
            <p:cNvPr id="60" name="Group 59"/>
            <p:cNvGrpSpPr/>
            <p:nvPr/>
          </p:nvGrpSpPr>
          <p:grpSpPr>
            <a:xfrm>
              <a:off x="4641548" y="1857983"/>
              <a:ext cx="819148" cy="2008223"/>
              <a:chOff x="5023935" y="1866296"/>
              <a:chExt cx="819148" cy="2008223"/>
            </a:xfrm>
          </p:grpSpPr>
          <p:sp>
            <p:nvSpPr>
              <p:cNvPr id="32" name="TextBox 31"/>
              <p:cNvSpPr txBox="1"/>
              <p:nvPr/>
            </p:nvSpPr>
            <p:spPr>
              <a:xfrm>
                <a:off x="5307359" y="1866296"/>
                <a:ext cx="53572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260</a:t>
                </a:r>
                <a:endParaRPr lang="en-US" dirty="0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5307359" y="2340909"/>
                <a:ext cx="53572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100</a:t>
                </a:r>
                <a:endParaRPr lang="en-US" dirty="0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5307359" y="2864426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50</a:t>
                </a:r>
                <a:endParaRPr lang="en-US" dirty="0"/>
              </a:p>
            </p:txBody>
          </p:sp>
          <p:grpSp>
            <p:nvGrpSpPr>
              <p:cNvPr id="47" name="Group 46"/>
              <p:cNvGrpSpPr/>
              <p:nvPr/>
            </p:nvGrpSpPr>
            <p:grpSpPr>
              <a:xfrm>
                <a:off x="5023935" y="2076198"/>
                <a:ext cx="293738" cy="1798321"/>
                <a:chOff x="5586164" y="3199364"/>
                <a:chExt cx="293738" cy="1798321"/>
              </a:xfrm>
            </p:grpSpPr>
            <p:cxnSp>
              <p:nvCxnSpPr>
                <p:cNvPr id="38" name="Straight Connector 37"/>
                <p:cNvCxnSpPr/>
                <p:nvPr/>
              </p:nvCxnSpPr>
              <p:spPr>
                <a:xfrm flipH="1">
                  <a:off x="5586164" y="3199364"/>
                  <a:ext cx="293738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" name="Straight Connector 38"/>
                <p:cNvCxnSpPr/>
                <p:nvPr/>
              </p:nvCxnSpPr>
              <p:spPr>
                <a:xfrm flipH="1">
                  <a:off x="5586164" y="3442326"/>
                  <a:ext cx="293738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" name="Straight Connector 39"/>
                <p:cNvCxnSpPr/>
                <p:nvPr/>
              </p:nvCxnSpPr>
              <p:spPr>
                <a:xfrm flipH="1">
                  <a:off x="5586164" y="3661979"/>
                  <a:ext cx="293738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" name="Straight Connector 40"/>
                <p:cNvCxnSpPr/>
                <p:nvPr/>
              </p:nvCxnSpPr>
              <p:spPr>
                <a:xfrm flipH="1">
                  <a:off x="5586164" y="3958594"/>
                  <a:ext cx="293738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2" name="Straight Connector 41"/>
                <p:cNvCxnSpPr/>
                <p:nvPr/>
              </p:nvCxnSpPr>
              <p:spPr>
                <a:xfrm flipH="1">
                  <a:off x="5586164" y="4183038"/>
                  <a:ext cx="293738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" name="Straight Connector 42"/>
                <p:cNvCxnSpPr/>
                <p:nvPr/>
              </p:nvCxnSpPr>
              <p:spPr>
                <a:xfrm flipH="1">
                  <a:off x="5586164" y="4390856"/>
                  <a:ext cx="293738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" name="Straight Connector 43"/>
                <p:cNvCxnSpPr/>
                <p:nvPr/>
              </p:nvCxnSpPr>
              <p:spPr>
                <a:xfrm flipH="1">
                  <a:off x="5586164" y="4631926"/>
                  <a:ext cx="293738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Straight Connector 44"/>
                <p:cNvCxnSpPr/>
                <p:nvPr/>
              </p:nvCxnSpPr>
              <p:spPr>
                <a:xfrm flipH="1">
                  <a:off x="5586164" y="4997685"/>
                  <a:ext cx="293738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8" name="TextBox 57"/>
              <p:cNvSpPr txBox="1"/>
              <p:nvPr/>
            </p:nvSpPr>
            <p:spPr>
              <a:xfrm>
                <a:off x="5307359" y="3305853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35</a:t>
                </a:r>
                <a:endParaRPr lang="en-US" dirty="0"/>
              </a:p>
            </p:txBody>
          </p:sp>
        </p:grpSp>
      </p:grpSp>
      <p:grpSp>
        <p:nvGrpSpPr>
          <p:cNvPr id="87" name="Group 86"/>
          <p:cNvGrpSpPr/>
          <p:nvPr/>
        </p:nvGrpSpPr>
        <p:grpSpPr>
          <a:xfrm>
            <a:off x="5895307" y="1358234"/>
            <a:ext cx="5272558" cy="2827212"/>
            <a:chOff x="5895307" y="1257996"/>
            <a:chExt cx="5272558" cy="2827212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102" t="8586" r="5167" b="-1"/>
            <a:stretch/>
          </p:blipFill>
          <p:spPr>
            <a:xfrm>
              <a:off x="5895307" y="1257996"/>
              <a:ext cx="4802549" cy="2827212"/>
            </a:xfrm>
            <a:prstGeom prst="rect">
              <a:avLst/>
            </a:prstGeom>
          </p:spPr>
        </p:pic>
        <p:grpSp>
          <p:nvGrpSpPr>
            <p:cNvPr id="61" name="Group 60"/>
            <p:cNvGrpSpPr/>
            <p:nvPr/>
          </p:nvGrpSpPr>
          <p:grpSpPr>
            <a:xfrm>
              <a:off x="10348717" y="1650169"/>
              <a:ext cx="819148" cy="2257605"/>
              <a:chOff x="5023935" y="1866296"/>
              <a:chExt cx="819148" cy="2257605"/>
            </a:xfrm>
          </p:grpSpPr>
          <p:sp>
            <p:nvSpPr>
              <p:cNvPr id="62" name="TextBox 61"/>
              <p:cNvSpPr txBox="1"/>
              <p:nvPr/>
            </p:nvSpPr>
            <p:spPr>
              <a:xfrm>
                <a:off x="5307359" y="1866296"/>
                <a:ext cx="53572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260</a:t>
                </a:r>
                <a:endParaRPr lang="en-US" dirty="0"/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5307359" y="2340909"/>
                <a:ext cx="53572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100</a:t>
                </a:r>
                <a:endParaRPr lang="en-US" dirty="0"/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5307359" y="2864426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50</a:t>
                </a:r>
                <a:endParaRPr lang="en-US" dirty="0"/>
              </a:p>
            </p:txBody>
          </p:sp>
          <p:grpSp>
            <p:nvGrpSpPr>
              <p:cNvPr id="65" name="Group 64"/>
              <p:cNvGrpSpPr/>
              <p:nvPr/>
            </p:nvGrpSpPr>
            <p:grpSpPr>
              <a:xfrm>
                <a:off x="5023935" y="2076198"/>
                <a:ext cx="293738" cy="2047703"/>
                <a:chOff x="5586164" y="3199364"/>
                <a:chExt cx="293738" cy="2047703"/>
              </a:xfrm>
            </p:grpSpPr>
            <p:cxnSp>
              <p:nvCxnSpPr>
                <p:cNvPr id="68" name="Straight Connector 67"/>
                <p:cNvCxnSpPr/>
                <p:nvPr/>
              </p:nvCxnSpPr>
              <p:spPr>
                <a:xfrm flipH="1">
                  <a:off x="5586164" y="3199364"/>
                  <a:ext cx="293738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9" name="Straight Connector 68"/>
                <p:cNvCxnSpPr/>
                <p:nvPr/>
              </p:nvCxnSpPr>
              <p:spPr>
                <a:xfrm flipH="1">
                  <a:off x="5586164" y="3442326"/>
                  <a:ext cx="293738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0" name="Straight Connector 69"/>
                <p:cNvCxnSpPr/>
                <p:nvPr/>
              </p:nvCxnSpPr>
              <p:spPr>
                <a:xfrm flipH="1">
                  <a:off x="5586164" y="3661979"/>
                  <a:ext cx="293738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1" name="Straight Connector 70"/>
                <p:cNvCxnSpPr/>
                <p:nvPr/>
              </p:nvCxnSpPr>
              <p:spPr>
                <a:xfrm flipH="1">
                  <a:off x="5586164" y="3958594"/>
                  <a:ext cx="293738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2" name="Straight Connector 71"/>
                <p:cNvCxnSpPr/>
                <p:nvPr/>
              </p:nvCxnSpPr>
              <p:spPr>
                <a:xfrm flipH="1">
                  <a:off x="5586164" y="4183038"/>
                  <a:ext cx="293738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3" name="Straight Connector 72"/>
                <p:cNvCxnSpPr/>
                <p:nvPr/>
              </p:nvCxnSpPr>
              <p:spPr>
                <a:xfrm flipH="1">
                  <a:off x="5586164" y="4390856"/>
                  <a:ext cx="293738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Straight Connector 73"/>
                <p:cNvCxnSpPr/>
                <p:nvPr/>
              </p:nvCxnSpPr>
              <p:spPr>
                <a:xfrm flipH="1">
                  <a:off x="5586164" y="4631926"/>
                  <a:ext cx="293738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" name="Straight Connector 74"/>
                <p:cNvCxnSpPr/>
                <p:nvPr/>
              </p:nvCxnSpPr>
              <p:spPr>
                <a:xfrm flipH="1">
                  <a:off x="5586164" y="4997685"/>
                  <a:ext cx="293738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6" name="Straight Connector 75"/>
                <p:cNvCxnSpPr/>
                <p:nvPr/>
              </p:nvCxnSpPr>
              <p:spPr>
                <a:xfrm flipH="1">
                  <a:off x="5586164" y="5247067"/>
                  <a:ext cx="293738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6" name="TextBox 65"/>
              <p:cNvSpPr txBox="1"/>
              <p:nvPr/>
            </p:nvSpPr>
            <p:spPr>
              <a:xfrm>
                <a:off x="5307359" y="3305853"/>
                <a:ext cx="41870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35</a:t>
                </a:r>
                <a:endParaRPr lang="en-US" dirty="0"/>
              </a:p>
            </p:txBody>
          </p:sp>
        </p:grpSp>
      </p:grpSp>
      <p:sp>
        <p:nvSpPr>
          <p:cNvPr id="77" name="TextBox 76"/>
          <p:cNvSpPr txBox="1"/>
          <p:nvPr/>
        </p:nvSpPr>
        <p:spPr>
          <a:xfrm>
            <a:off x="4210656" y="4252838"/>
            <a:ext cx="13847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WB: Fibronectin</a:t>
            </a:r>
            <a:endParaRPr lang="en-US" sz="1400" b="1" dirty="0"/>
          </a:p>
        </p:txBody>
      </p:sp>
      <p:grpSp>
        <p:nvGrpSpPr>
          <p:cNvPr id="79" name="Group 78"/>
          <p:cNvGrpSpPr/>
          <p:nvPr/>
        </p:nvGrpSpPr>
        <p:grpSpPr>
          <a:xfrm>
            <a:off x="6273024" y="706066"/>
            <a:ext cx="3958299" cy="732248"/>
            <a:chOff x="579426" y="827169"/>
            <a:chExt cx="3958299" cy="732248"/>
          </a:xfrm>
        </p:grpSpPr>
        <p:sp>
          <p:nvSpPr>
            <p:cNvPr id="80" name="TextBox 79"/>
            <p:cNvSpPr txBox="1"/>
            <p:nvPr/>
          </p:nvSpPr>
          <p:spPr>
            <a:xfrm>
              <a:off x="695804" y="1251640"/>
              <a:ext cx="18918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2’         10’      30’      60’</a:t>
              </a:r>
              <a:endParaRPr lang="en-US" sz="1400" b="1" dirty="0"/>
            </a:p>
          </p:txBody>
        </p:sp>
        <p:cxnSp>
          <p:nvCxnSpPr>
            <p:cNvPr id="81" name="Straight Connector 80"/>
            <p:cNvCxnSpPr/>
            <p:nvPr/>
          </p:nvCxnSpPr>
          <p:spPr>
            <a:xfrm>
              <a:off x="670867" y="1193821"/>
              <a:ext cx="1767884" cy="583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TextBox 81"/>
            <p:cNvSpPr txBox="1"/>
            <p:nvPr/>
          </p:nvSpPr>
          <p:spPr>
            <a:xfrm>
              <a:off x="579426" y="832593"/>
              <a:ext cx="19388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Neutrophils + CM61 EVs</a:t>
              </a:r>
              <a:endParaRPr lang="en-US" sz="1400" dirty="0"/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2555170" y="827169"/>
              <a:ext cx="195483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Neutrophils + HM59 EVs</a:t>
              </a:r>
              <a:endParaRPr lang="en-US" sz="1400" dirty="0"/>
            </a:p>
          </p:txBody>
        </p:sp>
        <p:cxnSp>
          <p:nvCxnSpPr>
            <p:cNvPr id="84" name="Straight Connector 83"/>
            <p:cNvCxnSpPr/>
            <p:nvPr/>
          </p:nvCxnSpPr>
          <p:spPr>
            <a:xfrm>
              <a:off x="2663193" y="1193821"/>
              <a:ext cx="1767884" cy="583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TextBox 84"/>
            <p:cNvSpPr txBox="1"/>
            <p:nvPr/>
          </p:nvSpPr>
          <p:spPr>
            <a:xfrm>
              <a:off x="2645860" y="1246216"/>
              <a:ext cx="18918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2’         10’      30’      60’</a:t>
              </a:r>
              <a:endParaRPr lang="en-US" sz="14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32827418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21" t="6987" r="12722" b="84724"/>
          <a:stretch/>
        </p:blipFill>
        <p:spPr>
          <a:xfrm>
            <a:off x="2711707" y="1833522"/>
            <a:ext cx="6768585" cy="392133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216131"/>
            <a:ext cx="12192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 smtClean="0"/>
              <a:t>Western Blot for Secreted </a:t>
            </a:r>
            <a:r>
              <a:rPr lang="en-US" sz="2400" b="1" dirty="0" smtClean="0"/>
              <a:t>Fibronectin and chemokines </a:t>
            </a:r>
            <a:r>
              <a:rPr lang="en-US" sz="2400" b="1" dirty="0" smtClean="0"/>
              <a:t>from Neutrophils treated with CM61 and </a:t>
            </a:r>
            <a:r>
              <a:rPr lang="en-US" sz="2400" b="1" dirty="0" smtClean="0"/>
              <a:t>or HM59 </a:t>
            </a:r>
            <a:r>
              <a:rPr lang="en-US" sz="2400" b="1" dirty="0" smtClean="0"/>
              <a:t>EVs (Supernatant)</a:t>
            </a:r>
            <a:endParaRPr lang="en-US" sz="24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2647103" y="2227839"/>
            <a:ext cx="683318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smtClean="0"/>
              <a:t>75698.137:          66904.572:        63581.108:        68987.815:      74675.986:        74805.815:         97710.350:        88745.693</a:t>
            </a:r>
            <a:endParaRPr lang="en-US" sz="1050" b="1" dirty="0"/>
          </a:p>
        </p:txBody>
      </p:sp>
      <p:sp>
        <p:nvSpPr>
          <p:cNvPr id="6" name="Rectangle 5"/>
          <p:cNvSpPr/>
          <p:nvPr/>
        </p:nvSpPr>
        <p:spPr>
          <a:xfrm>
            <a:off x="2696450" y="3030621"/>
            <a:ext cx="6783840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50" b="1" dirty="0" smtClean="0"/>
              <a:t>52462.137:        58610.380:        56501.622:         57129.702:       63214.622:         56110.359:        67392.915:       63473.894</a:t>
            </a:r>
            <a:endParaRPr lang="en-US" sz="105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2882630" y="1471599"/>
            <a:ext cx="29290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2’           10’           30’          60’</a:t>
            </a:r>
            <a:endParaRPr lang="en-US" b="1" dirty="0"/>
          </a:p>
        </p:txBody>
      </p:sp>
      <p:sp>
        <p:nvSpPr>
          <p:cNvPr id="10" name="Rectangle 9"/>
          <p:cNvSpPr/>
          <p:nvPr/>
        </p:nvSpPr>
        <p:spPr>
          <a:xfrm>
            <a:off x="2687478" y="1833770"/>
            <a:ext cx="6792813" cy="39188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324" t="62644" r="14040" b="27696"/>
          <a:stretch/>
        </p:blipFill>
        <p:spPr>
          <a:xfrm>
            <a:off x="2687477" y="2674249"/>
            <a:ext cx="6792813" cy="391885"/>
          </a:xfrm>
          <a:prstGeom prst="rect">
            <a:avLst/>
          </a:prstGeom>
        </p:spPr>
      </p:pic>
      <p:sp>
        <p:nvSpPr>
          <p:cNvPr id="13" name="Rectangle 12"/>
          <p:cNvSpPr/>
          <p:nvPr/>
        </p:nvSpPr>
        <p:spPr>
          <a:xfrm>
            <a:off x="2696450" y="2674249"/>
            <a:ext cx="6783840" cy="39188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>
            <a:off x="9520666" y="2849802"/>
            <a:ext cx="10855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WB: GAPDH</a:t>
            </a:r>
            <a:endParaRPr lang="en-US" sz="14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9520666" y="2017136"/>
            <a:ext cx="13847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WB: Fibronectin</a:t>
            </a:r>
            <a:endParaRPr lang="en-US" sz="14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6280998" y="1456024"/>
            <a:ext cx="29290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2’           10’           30’          60’</a:t>
            </a:r>
            <a:endParaRPr lang="en-US" b="1" dirty="0"/>
          </a:p>
        </p:txBody>
      </p:sp>
      <p:cxnSp>
        <p:nvCxnSpPr>
          <p:cNvPr id="19" name="Straight Connector 18"/>
          <p:cNvCxnSpPr/>
          <p:nvPr/>
        </p:nvCxnSpPr>
        <p:spPr>
          <a:xfrm flipV="1">
            <a:off x="2882630" y="1376749"/>
            <a:ext cx="2765412" cy="831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V="1">
            <a:off x="6280998" y="1384928"/>
            <a:ext cx="2765412" cy="831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2882630" y="1052552"/>
            <a:ext cx="2437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eutrophils + CM61 EVs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6230608" y="1047128"/>
            <a:ext cx="24583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eutrophils + HM59 EVs</a:t>
            </a:r>
            <a:endParaRPr lang="en-US" dirty="0"/>
          </a:p>
        </p:txBody>
      </p:sp>
      <p:grpSp>
        <p:nvGrpSpPr>
          <p:cNvPr id="18" name="Group 17"/>
          <p:cNvGrpSpPr/>
          <p:nvPr/>
        </p:nvGrpSpPr>
        <p:grpSpPr>
          <a:xfrm flipH="1">
            <a:off x="2222471" y="2504289"/>
            <a:ext cx="489236" cy="731803"/>
            <a:chOff x="4914281" y="2934399"/>
            <a:chExt cx="397457" cy="731803"/>
          </a:xfrm>
        </p:grpSpPr>
        <p:sp>
          <p:nvSpPr>
            <p:cNvPr id="23" name="TextBox 22"/>
            <p:cNvSpPr txBox="1"/>
            <p:nvPr/>
          </p:nvSpPr>
          <p:spPr>
            <a:xfrm>
              <a:off x="4914282" y="2934399"/>
              <a:ext cx="3974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40-</a:t>
              </a:r>
              <a:endParaRPr lang="en-US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914281" y="3296870"/>
              <a:ext cx="3974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35-</a:t>
              </a:r>
              <a:endParaRPr lang="en-US" dirty="0"/>
            </a:p>
          </p:txBody>
        </p:sp>
      </p:grpSp>
      <p:sp>
        <p:nvSpPr>
          <p:cNvPr id="27" name="TextBox 26"/>
          <p:cNvSpPr txBox="1"/>
          <p:nvPr/>
        </p:nvSpPr>
        <p:spPr>
          <a:xfrm flipH="1">
            <a:off x="2106252" y="2017443"/>
            <a:ext cx="7216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&gt;260-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7358318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0" y="216131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Chemokine arrays</a:t>
            </a:r>
            <a:endParaRPr lang="en-US" dirty="0"/>
          </a:p>
        </p:txBody>
      </p:sp>
      <p:pic>
        <p:nvPicPr>
          <p:cNvPr id="57" name="Picture 5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210" t="84111" r="38000" b="3099"/>
          <a:stretch/>
        </p:blipFill>
        <p:spPr>
          <a:xfrm>
            <a:off x="899341" y="5266688"/>
            <a:ext cx="3942318" cy="1451612"/>
          </a:xfrm>
          <a:prstGeom prst="rect">
            <a:avLst/>
          </a:prstGeom>
        </p:spPr>
      </p:pic>
      <p:pic>
        <p:nvPicPr>
          <p:cNvPr id="59" name="Picture 58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210" t="55810" r="38000" b="31004"/>
          <a:stretch/>
        </p:blipFill>
        <p:spPr>
          <a:xfrm>
            <a:off x="899341" y="3680295"/>
            <a:ext cx="3942319" cy="1496621"/>
          </a:xfrm>
          <a:prstGeom prst="rect">
            <a:avLst/>
          </a:prstGeom>
        </p:spPr>
      </p:pic>
      <p:pic>
        <p:nvPicPr>
          <p:cNvPr id="60" name="Picture 5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210" t="29791" r="38000" b="57473"/>
          <a:stretch/>
        </p:blipFill>
        <p:spPr>
          <a:xfrm>
            <a:off x="899341" y="2145006"/>
            <a:ext cx="3942319" cy="1445517"/>
          </a:xfrm>
          <a:prstGeom prst="rect">
            <a:avLst/>
          </a:prstGeom>
        </p:spPr>
      </p:pic>
      <p:pic>
        <p:nvPicPr>
          <p:cNvPr id="61" name="Picture 6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210" t="4106" r="38000" b="83426"/>
          <a:stretch/>
        </p:blipFill>
        <p:spPr>
          <a:xfrm>
            <a:off x="899341" y="640123"/>
            <a:ext cx="3942318" cy="1415111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4900970" y="1163012"/>
            <a:ext cx="3593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2’</a:t>
            </a:r>
            <a:endParaRPr lang="en-US" b="1" dirty="0"/>
          </a:p>
        </p:txBody>
      </p:sp>
      <p:sp>
        <p:nvSpPr>
          <p:cNvPr id="62" name="TextBox 61"/>
          <p:cNvSpPr txBox="1"/>
          <p:nvPr/>
        </p:nvSpPr>
        <p:spPr>
          <a:xfrm>
            <a:off x="4841659" y="2684871"/>
            <a:ext cx="478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10’</a:t>
            </a:r>
            <a:endParaRPr lang="en-US" b="1" dirty="0"/>
          </a:p>
        </p:txBody>
      </p:sp>
      <p:sp>
        <p:nvSpPr>
          <p:cNvPr id="63" name="TextBox 62"/>
          <p:cNvSpPr txBox="1"/>
          <p:nvPr/>
        </p:nvSpPr>
        <p:spPr>
          <a:xfrm>
            <a:off x="4841659" y="4243939"/>
            <a:ext cx="478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30’</a:t>
            </a:r>
            <a:endParaRPr lang="en-US" b="1" dirty="0"/>
          </a:p>
        </p:txBody>
      </p:sp>
      <p:sp>
        <p:nvSpPr>
          <p:cNvPr id="66" name="TextBox 65"/>
          <p:cNvSpPr txBox="1"/>
          <p:nvPr/>
        </p:nvSpPr>
        <p:spPr>
          <a:xfrm>
            <a:off x="4841659" y="5807828"/>
            <a:ext cx="478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60’</a:t>
            </a:r>
            <a:endParaRPr lang="en-US" b="1" dirty="0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3"/>
          <a:srcRect l="71882" t="47284" r="15208" b="29136"/>
          <a:stretch/>
        </p:blipFill>
        <p:spPr>
          <a:xfrm>
            <a:off x="6441564" y="1889919"/>
            <a:ext cx="4721942" cy="2425700"/>
          </a:xfrm>
          <a:prstGeom prst="rect">
            <a:avLst/>
          </a:prstGeom>
        </p:spPr>
      </p:pic>
      <p:grpSp>
        <p:nvGrpSpPr>
          <p:cNvPr id="2" name="Group 1"/>
          <p:cNvGrpSpPr/>
          <p:nvPr/>
        </p:nvGrpSpPr>
        <p:grpSpPr>
          <a:xfrm>
            <a:off x="1514476" y="1128484"/>
            <a:ext cx="2733228" cy="476488"/>
            <a:chOff x="1514476" y="1128484"/>
            <a:chExt cx="2733228" cy="476488"/>
          </a:xfrm>
        </p:grpSpPr>
        <p:sp>
          <p:nvSpPr>
            <p:cNvPr id="21" name="Rectangle 20"/>
            <p:cNvSpPr/>
            <p:nvPr/>
          </p:nvSpPr>
          <p:spPr>
            <a:xfrm>
              <a:off x="1514476" y="1452563"/>
              <a:ext cx="279588" cy="1452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/>
            <p:cNvSpPr/>
            <p:nvPr/>
          </p:nvSpPr>
          <p:spPr>
            <a:xfrm>
              <a:off x="2238925" y="1452563"/>
              <a:ext cx="279588" cy="1452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 16"/>
            <p:cNvSpPr/>
            <p:nvPr/>
          </p:nvSpPr>
          <p:spPr>
            <a:xfrm>
              <a:off x="2951498" y="1459716"/>
              <a:ext cx="279588" cy="1452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Rectangle 17"/>
            <p:cNvSpPr/>
            <p:nvPr/>
          </p:nvSpPr>
          <p:spPr>
            <a:xfrm>
              <a:off x="2951498" y="1152589"/>
              <a:ext cx="279588" cy="1452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2564114" y="1128484"/>
              <a:ext cx="279588" cy="1452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3968116" y="1145102"/>
              <a:ext cx="279588" cy="1452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2" name="Group 21"/>
          <p:cNvGrpSpPr/>
          <p:nvPr/>
        </p:nvGrpSpPr>
        <p:grpSpPr>
          <a:xfrm>
            <a:off x="1547487" y="2611657"/>
            <a:ext cx="2733228" cy="476488"/>
            <a:chOff x="1514476" y="1128484"/>
            <a:chExt cx="2733228" cy="476488"/>
          </a:xfrm>
        </p:grpSpPr>
        <p:sp>
          <p:nvSpPr>
            <p:cNvPr id="23" name="Rectangle 22"/>
            <p:cNvSpPr/>
            <p:nvPr/>
          </p:nvSpPr>
          <p:spPr>
            <a:xfrm>
              <a:off x="1514476" y="1452563"/>
              <a:ext cx="279588" cy="1452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Rectangle 23"/>
            <p:cNvSpPr/>
            <p:nvPr/>
          </p:nvSpPr>
          <p:spPr>
            <a:xfrm>
              <a:off x="2238925" y="1452563"/>
              <a:ext cx="279588" cy="1452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Rectangle 24"/>
            <p:cNvSpPr/>
            <p:nvPr/>
          </p:nvSpPr>
          <p:spPr>
            <a:xfrm>
              <a:off x="2951498" y="1459716"/>
              <a:ext cx="279588" cy="1452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Rectangle 25"/>
            <p:cNvSpPr/>
            <p:nvPr/>
          </p:nvSpPr>
          <p:spPr>
            <a:xfrm>
              <a:off x="2951498" y="1152589"/>
              <a:ext cx="279588" cy="1452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Rectangle 26"/>
            <p:cNvSpPr/>
            <p:nvPr/>
          </p:nvSpPr>
          <p:spPr>
            <a:xfrm>
              <a:off x="2564114" y="1128484"/>
              <a:ext cx="279588" cy="1452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Rectangle 27"/>
            <p:cNvSpPr/>
            <p:nvPr/>
          </p:nvSpPr>
          <p:spPr>
            <a:xfrm>
              <a:off x="3968116" y="1145102"/>
              <a:ext cx="279588" cy="1452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" name="Group 28"/>
          <p:cNvGrpSpPr/>
          <p:nvPr/>
        </p:nvGrpSpPr>
        <p:grpSpPr>
          <a:xfrm>
            <a:off x="1594486" y="4173489"/>
            <a:ext cx="2733228" cy="476488"/>
            <a:chOff x="1514476" y="1128484"/>
            <a:chExt cx="2733228" cy="476488"/>
          </a:xfrm>
        </p:grpSpPr>
        <p:sp>
          <p:nvSpPr>
            <p:cNvPr id="30" name="Rectangle 29"/>
            <p:cNvSpPr/>
            <p:nvPr/>
          </p:nvSpPr>
          <p:spPr>
            <a:xfrm>
              <a:off x="1514476" y="1452563"/>
              <a:ext cx="279588" cy="1452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" name="Rectangle 30"/>
            <p:cNvSpPr/>
            <p:nvPr/>
          </p:nvSpPr>
          <p:spPr>
            <a:xfrm>
              <a:off x="2238925" y="1452563"/>
              <a:ext cx="279588" cy="1452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Rectangle 31"/>
            <p:cNvSpPr/>
            <p:nvPr/>
          </p:nvSpPr>
          <p:spPr>
            <a:xfrm>
              <a:off x="2951498" y="1459716"/>
              <a:ext cx="279588" cy="1452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" name="Rectangle 32"/>
            <p:cNvSpPr/>
            <p:nvPr/>
          </p:nvSpPr>
          <p:spPr>
            <a:xfrm>
              <a:off x="2951498" y="1152589"/>
              <a:ext cx="279588" cy="1452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Rectangle 33"/>
            <p:cNvSpPr/>
            <p:nvPr/>
          </p:nvSpPr>
          <p:spPr>
            <a:xfrm>
              <a:off x="2564114" y="1128484"/>
              <a:ext cx="279588" cy="1452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" name="Rectangle 34"/>
            <p:cNvSpPr/>
            <p:nvPr/>
          </p:nvSpPr>
          <p:spPr>
            <a:xfrm>
              <a:off x="3968116" y="1145102"/>
              <a:ext cx="279588" cy="1452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6" name="Group 35"/>
          <p:cNvGrpSpPr/>
          <p:nvPr/>
        </p:nvGrpSpPr>
        <p:grpSpPr>
          <a:xfrm>
            <a:off x="1454692" y="5830024"/>
            <a:ext cx="2733228" cy="476488"/>
            <a:chOff x="1514476" y="1128484"/>
            <a:chExt cx="2733228" cy="476488"/>
          </a:xfrm>
        </p:grpSpPr>
        <p:sp>
          <p:nvSpPr>
            <p:cNvPr id="37" name="Rectangle 36"/>
            <p:cNvSpPr/>
            <p:nvPr/>
          </p:nvSpPr>
          <p:spPr>
            <a:xfrm>
              <a:off x="1514476" y="1452563"/>
              <a:ext cx="279588" cy="1452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Rectangle 37"/>
            <p:cNvSpPr/>
            <p:nvPr/>
          </p:nvSpPr>
          <p:spPr>
            <a:xfrm>
              <a:off x="2238925" y="1452563"/>
              <a:ext cx="279588" cy="1452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" name="Rectangle 38"/>
            <p:cNvSpPr/>
            <p:nvPr/>
          </p:nvSpPr>
          <p:spPr>
            <a:xfrm>
              <a:off x="2951498" y="1459716"/>
              <a:ext cx="279588" cy="1452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" name="Rectangle 39"/>
            <p:cNvSpPr/>
            <p:nvPr/>
          </p:nvSpPr>
          <p:spPr>
            <a:xfrm>
              <a:off x="2951498" y="1152589"/>
              <a:ext cx="279588" cy="1452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" name="Rectangle 40"/>
            <p:cNvSpPr/>
            <p:nvPr/>
          </p:nvSpPr>
          <p:spPr>
            <a:xfrm>
              <a:off x="2564114" y="1128484"/>
              <a:ext cx="279588" cy="1452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2" name="Rectangle 41"/>
            <p:cNvSpPr/>
            <p:nvPr/>
          </p:nvSpPr>
          <p:spPr>
            <a:xfrm>
              <a:off x="3968116" y="1145102"/>
              <a:ext cx="279588" cy="14525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80000070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0" y="0"/>
            <a:ext cx="12192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 smtClean="0"/>
              <a:t>Chemokine arrays</a:t>
            </a:r>
            <a:endParaRPr lang="en-US" sz="2400" b="1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69382" t="14973" r="15000" b="15044"/>
          <a:stretch/>
        </p:blipFill>
        <p:spPr>
          <a:xfrm>
            <a:off x="3802743" y="585463"/>
            <a:ext cx="4905828" cy="61824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468067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0" y="70740"/>
            <a:ext cx="12192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 smtClean="0"/>
              <a:t>Chemokine arrays</a:t>
            </a:r>
            <a:endParaRPr lang="en-US" sz="24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9081462" y="1147033"/>
            <a:ext cx="146469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E3,4: CXCL7 </a:t>
            </a:r>
            <a:endParaRPr lang="en-US" sz="2000" b="1" dirty="0"/>
          </a:p>
        </p:txBody>
      </p:sp>
      <p:sp>
        <p:nvSpPr>
          <p:cNvPr id="92" name="TextBox 91"/>
          <p:cNvSpPr txBox="1"/>
          <p:nvPr/>
        </p:nvSpPr>
        <p:spPr>
          <a:xfrm>
            <a:off x="9081462" y="2101105"/>
            <a:ext cx="146469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E7,8: CXCL4 </a:t>
            </a:r>
            <a:endParaRPr lang="en-US" sz="2000" b="1" dirty="0"/>
          </a:p>
        </p:txBody>
      </p:sp>
      <p:sp>
        <p:nvSpPr>
          <p:cNvPr id="100" name="TextBox 99"/>
          <p:cNvSpPr txBox="1"/>
          <p:nvPr/>
        </p:nvSpPr>
        <p:spPr>
          <a:xfrm>
            <a:off x="9081462" y="3055177"/>
            <a:ext cx="184140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E11/12: CXCL12</a:t>
            </a:r>
            <a:endParaRPr lang="en-US" sz="2000" b="1" dirty="0"/>
          </a:p>
        </p:txBody>
      </p:sp>
      <p:sp>
        <p:nvSpPr>
          <p:cNvPr id="105" name="TextBox 104"/>
          <p:cNvSpPr txBox="1"/>
          <p:nvPr/>
        </p:nvSpPr>
        <p:spPr>
          <a:xfrm>
            <a:off x="9081462" y="4009249"/>
            <a:ext cx="15905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C17/18: CCL2</a:t>
            </a:r>
            <a:endParaRPr lang="en-US" sz="2000" b="1" dirty="0"/>
          </a:p>
        </p:txBody>
      </p:sp>
      <p:sp>
        <p:nvSpPr>
          <p:cNvPr id="126" name="TextBox 125"/>
          <p:cNvSpPr txBox="1"/>
          <p:nvPr/>
        </p:nvSpPr>
        <p:spPr>
          <a:xfrm>
            <a:off x="9081462" y="4963321"/>
            <a:ext cx="138691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C9/10: IL16</a:t>
            </a:r>
            <a:endParaRPr lang="en-US" sz="2000" b="1" dirty="0"/>
          </a:p>
        </p:txBody>
      </p:sp>
      <p:sp>
        <p:nvSpPr>
          <p:cNvPr id="127" name="TextBox 126"/>
          <p:cNvSpPr txBox="1"/>
          <p:nvPr/>
        </p:nvSpPr>
        <p:spPr>
          <a:xfrm>
            <a:off x="9081462" y="5917394"/>
            <a:ext cx="185262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C11/12: CXCL10</a:t>
            </a:r>
            <a:endParaRPr lang="en-US" sz="2000" b="1" dirty="0"/>
          </a:p>
        </p:txBody>
      </p:sp>
      <p:grpSp>
        <p:nvGrpSpPr>
          <p:cNvPr id="12" name="Group 11"/>
          <p:cNvGrpSpPr/>
          <p:nvPr/>
        </p:nvGrpSpPr>
        <p:grpSpPr>
          <a:xfrm>
            <a:off x="3464414" y="1042799"/>
            <a:ext cx="5560032" cy="679380"/>
            <a:chOff x="3484028" y="1042799"/>
            <a:chExt cx="5560032" cy="679380"/>
          </a:xfrm>
        </p:grpSpPr>
        <p:grpSp>
          <p:nvGrpSpPr>
            <p:cNvPr id="24" name="Group 23"/>
            <p:cNvGrpSpPr/>
            <p:nvPr/>
          </p:nvGrpSpPr>
          <p:grpSpPr>
            <a:xfrm>
              <a:off x="3484028" y="1042799"/>
              <a:ext cx="1359450" cy="679380"/>
              <a:chOff x="6032234" y="3512374"/>
              <a:chExt cx="1359450" cy="679380"/>
            </a:xfrm>
          </p:grpSpPr>
          <p:pic>
            <p:nvPicPr>
              <p:cNvPr id="70" name="Picture 69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8553" t="11217" r="59298" b="87441"/>
              <a:stretch/>
            </p:blipFill>
            <p:spPr>
              <a:xfrm>
                <a:off x="6032234" y="3512374"/>
                <a:ext cx="1359450" cy="679380"/>
              </a:xfrm>
              <a:prstGeom prst="rect">
                <a:avLst/>
              </a:prstGeom>
            </p:spPr>
          </p:pic>
          <p:sp>
            <p:nvSpPr>
              <p:cNvPr id="23" name="Rectangle 22"/>
              <p:cNvSpPr/>
              <p:nvPr/>
            </p:nvSpPr>
            <p:spPr>
              <a:xfrm>
                <a:off x="6035105" y="3520289"/>
                <a:ext cx="1356579" cy="67146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25" name="Group 24"/>
            <p:cNvGrpSpPr/>
            <p:nvPr/>
          </p:nvGrpSpPr>
          <p:grpSpPr>
            <a:xfrm>
              <a:off x="4889053" y="1046757"/>
              <a:ext cx="1359450" cy="671465"/>
              <a:chOff x="7435949" y="3520289"/>
              <a:chExt cx="1359450" cy="671465"/>
            </a:xfrm>
          </p:grpSpPr>
          <p:pic>
            <p:nvPicPr>
              <p:cNvPr id="71" name="Picture 70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8608" t="37044" r="59243" b="61655"/>
              <a:stretch/>
            </p:blipFill>
            <p:spPr>
              <a:xfrm>
                <a:off x="7435949" y="3525414"/>
                <a:ext cx="1359450" cy="658620"/>
              </a:xfrm>
              <a:prstGeom prst="rect">
                <a:avLst/>
              </a:prstGeom>
            </p:spPr>
          </p:pic>
          <p:sp>
            <p:nvSpPr>
              <p:cNvPr id="128" name="Rectangle 127"/>
              <p:cNvSpPr/>
              <p:nvPr/>
            </p:nvSpPr>
            <p:spPr>
              <a:xfrm>
                <a:off x="7435949" y="3520289"/>
                <a:ext cx="1356579" cy="67146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27" name="Group 26"/>
            <p:cNvGrpSpPr/>
            <p:nvPr/>
          </p:nvGrpSpPr>
          <p:grpSpPr>
            <a:xfrm>
              <a:off x="7670060" y="1044357"/>
              <a:ext cx="1374000" cy="676265"/>
              <a:chOff x="10297507" y="3554930"/>
              <a:chExt cx="1374000" cy="676265"/>
            </a:xfrm>
          </p:grpSpPr>
          <p:pic>
            <p:nvPicPr>
              <p:cNvPr id="73" name="Picture 72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969" t="92088" r="59859" b="6590"/>
              <a:stretch/>
            </p:blipFill>
            <p:spPr>
              <a:xfrm>
                <a:off x="10297507" y="3554930"/>
                <a:ext cx="1374000" cy="669260"/>
              </a:xfrm>
              <a:prstGeom prst="rect">
                <a:avLst/>
              </a:prstGeom>
            </p:spPr>
          </p:pic>
          <p:sp>
            <p:nvSpPr>
              <p:cNvPr id="130" name="Rectangle 129"/>
              <p:cNvSpPr/>
              <p:nvPr/>
            </p:nvSpPr>
            <p:spPr>
              <a:xfrm>
                <a:off x="10304650" y="3559730"/>
                <a:ext cx="1356579" cy="67146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26" name="Group 25"/>
            <p:cNvGrpSpPr/>
            <p:nvPr/>
          </p:nvGrpSpPr>
          <p:grpSpPr>
            <a:xfrm>
              <a:off x="6286541" y="1046757"/>
              <a:ext cx="1360720" cy="671465"/>
              <a:chOff x="8867582" y="3524348"/>
              <a:chExt cx="1360720" cy="671465"/>
            </a:xfrm>
          </p:grpSpPr>
          <p:pic>
            <p:nvPicPr>
              <p:cNvPr id="72" name="Picture 71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8936" t="62981" r="58913" b="35710"/>
              <a:stretch/>
            </p:blipFill>
            <p:spPr>
              <a:xfrm>
                <a:off x="8867582" y="3529084"/>
                <a:ext cx="1360720" cy="662670"/>
              </a:xfrm>
              <a:prstGeom prst="rect">
                <a:avLst/>
              </a:prstGeom>
            </p:spPr>
          </p:pic>
          <p:sp>
            <p:nvSpPr>
              <p:cNvPr id="129" name="Rectangle 128"/>
              <p:cNvSpPr/>
              <p:nvPr/>
            </p:nvSpPr>
            <p:spPr>
              <a:xfrm>
                <a:off x="8871723" y="3524348"/>
                <a:ext cx="1356579" cy="67146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13" name="Group 12"/>
          <p:cNvGrpSpPr/>
          <p:nvPr/>
        </p:nvGrpSpPr>
        <p:grpSpPr>
          <a:xfrm>
            <a:off x="3464414" y="1969467"/>
            <a:ext cx="5547817" cy="679706"/>
            <a:chOff x="3487533" y="1895496"/>
            <a:chExt cx="5547817" cy="679706"/>
          </a:xfrm>
        </p:grpSpPr>
        <p:grpSp>
          <p:nvGrpSpPr>
            <p:cNvPr id="28" name="Group 27"/>
            <p:cNvGrpSpPr/>
            <p:nvPr/>
          </p:nvGrpSpPr>
          <p:grpSpPr>
            <a:xfrm>
              <a:off x="3487533" y="1895584"/>
              <a:ext cx="1367680" cy="679530"/>
              <a:chOff x="3069070" y="1897173"/>
              <a:chExt cx="1367680" cy="679530"/>
            </a:xfrm>
          </p:grpSpPr>
          <p:pic>
            <p:nvPicPr>
              <p:cNvPr id="88" name="Picture 87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5755" t="11250" r="52083" b="87429"/>
              <a:stretch/>
            </p:blipFill>
            <p:spPr>
              <a:xfrm>
                <a:off x="3069070" y="1897173"/>
                <a:ext cx="1367680" cy="668750"/>
              </a:xfrm>
              <a:prstGeom prst="rect">
                <a:avLst/>
              </a:prstGeom>
            </p:spPr>
          </p:pic>
          <p:sp>
            <p:nvSpPr>
              <p:cNvPr id="131" name="Rectangle 130"/>
              <p:cNvSpPr/>
              <p:nvPr/>
            </p:nvSpPr>
            <p:spPr>
              <a:xfrm>
                <a:off x="3074159" y="1905238"/>
                <a:ext cx="1356579" cy="67146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33" name="Group 32"/>
            <p:cNvGrpSpPr/>
            <p:nvPr/>
          </p:nvGrpSpPr>
          <p:grpSpPr>
            <a:xfrm>
              <a:off x="4890489" y="1899617"/>
              <a:ext cx="1356579" cy="671465"/>
              <a:chOff x="7591689" y="4671957"/>
              <a:chExt cx="1356579" cy="671465"/>
            </a:xfrm>
          </p:grpSpPr>
          <p:pic>
            <p:nvPicPr>
              <p:cNvPr id="89" name="Picture 88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3751" t="36756" r="54125" b="61946"/>
              <a:stretch/>
            </p:blipFill>
            <p:spPr>
              <a:xfrm>
                <a:off x="7595677" y="4676016"/>
                <a:ext cx="1343536" cy="657110"/>
              </a:xfrm>
              <a:prstGeom prst="rect">
                <a:avLst/>
              </a:prstGeom>
            </p:spPr>
          </p:pic>
          <p:sp>
            <p:nvSpPr>
              <p:cNvPr id="132" name="Rectangle 131"/>
              <p:cNvSpPr/>
              <p:nvPr/>
            </p:nvSpPr>
            <p:spPr>
              <a:xfrm>
                <a:off x="7591689" y="4671957"/>
                <a:ext cx="1356579" cy="67146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36" name="Group 35"/>
            <p:cNvGrpSpPr/>
            <p:nvPr/>
          </p:nvGrpSpPr>
          <p:grpSpPr>
            <a:xfrm>
              <a:off x="7678771" y="1899617"/>
              <a:ext cx="1356579" cy="671465"/>
              <a:chOff x="10686060" y="4540850"/>
              <a:chExt cx="1356579" cy="671465"/>
            </a:xfrm>
          </p:grpSpPr>
          <p:pic>
            <p:nvPicPr>
              <p:cNvPr id="91" name="Picture 90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3357" t="91773" r="54518" b="6922"/>
              <a:stretch/>
            </p:blipFill>
            <p:spPr>
              <a:xfrm>
                <a:off x="10695678" y="4548497"/>
                <a:ext cx="1343922" cy="660650"/>
              </a:xfrm>
              <a:prstGeom prst="rect">
                <a:avLst/>
              </a:prstGeom>
            </p:spPr>
          </p:pic>
          <p:sp>
            <p:nvSpPr>
              <p:cNvPr id="134" name="Rectangle 133"/>
              <p:cNvSpPr/>
              <p:nvPr/>
            </p:nvSpPr>
            <p:spPr>
              <a:xfrm>
                <a:off x="10686060" y="4540850"/>
                <a:ext cx="1356579" cy="67146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35" name="Group 34"/>
            <p:cNvGrpSpPr/>
            <p:nvPr/>
          </p:nvGrpSpPr>
          <p:grpSpPr>
            <a:xfrm>
              <a:off x="6284112" y="1895496"/>
              <a:ext cx="1365578" cy="679706"/>
              <a:chOff x="8997622" y="4663716"/>
              <a:chExt cx="1365578" cy="679706"/>
            </a:xfrm>
          </p:grpSpPr>
          <p:pic>
            <p:nvPicPr>
              <p:cNvPr id="90" name="Picture 89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4248" t="63055" r="53622" b="35607"/>
              <a:stretch/>
            </p:blipFill>
            <p:spPr>
              <a:xfrm>
                <a:off x="9015413" y="4663716"/>
                <a:ext cx="1347787" cy="677427"/>
              </a:xfrm>
              <a:prstGeom prst="rect">
                <a:avLst/>
              </a:prstGeom>
            </p:spPr>
          </p:pic>
          <p:sp>
            <p:nvSpPr>
              <p:cNvPr id="133" name="Rectangle 132"/>
              <p:cNvSpPr/>
              <p:nvPr/>
            </p:nvSpPr>
            <p:spPr>
              <a:xfrm>
                <a:off x="8997622" y="4671957"/>
                <a:ext cx="1356579" cy="67146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21" name="Group 20"/>
          <p:cNvGrpSpPr/>
          <p:nvPr/>
        </p:nvGrpSpPr>
        <p:grpSpPr>
          <a:xfrm>
            <a:off x="3464414" y="2896461"/>
            <a:ext cx="5541657" cy="685960"/>
            <a:chOff x="3486899" y="2750892"/>
            <a:chExt cx="5541657" cy="685960"/>
          </a:xfrm>
        </p:grpSpPr>
        <p:grpSp>
          <p:nvGrpSpPr>
            <p:cNvPr id="6" name="Group 5"/>
            <p:cNvGrpSpPr/>
            <p:nvPr/>
          </p:nvGrpSpPr>
          <p:grpSpPr>
            <a:xfrm>
              <a:off x="7666576" y="2750892"/>
              <a:ext cx="1361980" cy="685960"/>
              <a:chOff x="7543084" y="3006722"/>
              <a:chExt cx="1361980" cy="685960"/>
            </a:xfrm>
          </p:grpSpPr>
          <p:pic>
            <p:nvPicPr>
              <p:cNvPr id="96" name="Picture 95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163" t="91766" r="49684" b="6879"/>
              <a:stretch/>
            </p:blipFill>
            <p:spPr>
              <a:xfrm>
                <a:off x="7543084" y="3006722"/>
                <a:ext cx="1361980" cy="685960"/>
              </a:xfrm>
              <a:prstGeom prst="rect">
                <a:avLst/>
              </a:prstGeom>
            </p:spPr>
          </p:pic>
          <p:sp>
            <p:nvSpPr>
              <p:cNvPr id="67" name="Rectangle 66"/>
              <p:cNvSpPr/>
              <p:nvPr/>
            </p:nvSpPr>
            <p:spPr>
              <a:xfrm>
                <a:off x="7548485" y="3011621"/>
                <a:ext cx="1356579" cy="67146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5" name="Group 4"/>
            <p:cNvGrpSpPr/>
            <p:nvPr/>
          </p:nvGrpSpPr>
          <p:grpSpPr>
            <a:xfrm>
              <a:off x="6272849" y="2758140"/>
              <a:ext cx="1369117" cy="671465"/>
              <a:chOff x="6088170" y="3080605"/>
              <a:chExt cx="1369117" cy="671465"/>
            </a:xfrm>
          </p:grpSpPr>
          <p:pic>
            <p:nvPicPr>
              <p:cNvPr id="95" name="Picture 94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168" t="62996" r="48674" b="35686"/>
              <a:stretch/>
            </p:blipFill>
            <p:spPr>
              <a:xfrm>
                <a:off x="6088170" y="3082723"/>
                <a:ext cx="1365143" cy="667230"/>
              </a:xfrm>
              <a:prstGeom prst="rect">
                <a:avLst/>
              </a:prstGeom>
            </p:spPr>
          </p:pic>
          <p:sp>
            <p:nvSpPr>
              <p:cNvPr id="65" name="Rectangle 64"/>
              <p:cNvSpPr/>
              <p:nvPr/>
            </p:nvSpPr>
            <p:spPr>
              <a:xfrm>
                <a:off x="6100708" y="3080605"/>
                <a:ext cx="1356579" cy="67146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86" name="Group 85"/>
            <p:cNvGrpSpPr/>
            <p:nvPr/>
          </p:nvGrpSpPr>
          <p:grpSpPr>
            <a:xfrm>
              <a:off x="3486899" y="2757157"/>
              <a:ext cx="1358820" cy="673430"/>
              <a:chOff x="3130602" y="3225887"/>
              <a:chExt cx="1358820" cy="673430"/>
            </a:xfrm>
          </p:grpSpPr>
          <p:pic>
            <p:nvPicPr>
              <p:cNvPr id="87" name="Picture 86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683" t="11418" r="49169" b="87267"/>
              <a:stretch/>
            </p:blipFill>
            <p:spPr>
              <a:xfrm>
                <a:off x="3130602" y="3233607"/>
                <a:ext cx="1358820" cy="665710"/>
              </a:xfrm>
              <a:prstGeom prst="rect">
                <a:avLst/>
              </a:prstGeom>
            </p:spPr>
          </p:pic>
          <p:sp>
            <p:nvSpPr>
              <p:cNvPr id="97" name="Rectangle 96"/>
              <p:cNvSpPr/>
              <p:nvPr/>
            </p:nvSpPr>
            <p:spPr>
              <a:xfrm>
                <a:off x="3132843" y="3225887"/>
                <a:ext cx="1356579" cy="67146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18" name="Group 117"/>
            <p:cNvGrpSpPr/>
            <p:nvPr/>
          </p:nvGrpSpPr>
          <p:grpSpPr>
            <a:xfrm>
              <a:off x="4893045" y="2758140"/>
              <a:ext cx="1356579" cy="671465"/>
              <a:chOff x="4641822" y="3141117"/>
              <a:chExt cx="1356579" cy="671465"/>
            </a:xfrm>
          </p:grpSpPr>
          <p:pic>
            <p:nvPicPr>
              <p:cNvPr id="119" name="Picture 118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821" t="36719" r="49051" b="61963"/>
              <a:stretch/>
            </p:blipFill>
            <p:spPr>
              <a:xfrm>
                <a:off x="4645195" y="3145631"/>
                <a:ext cx="1346030" cy="666951"/>
              </a:xfrm>
              <a:prstGeom prst="rect">
                <a:avLst/>
              </a:prstGeom>
            </p:spPr>
          </p:pic>
          <p:sp>
            <p:nvSpPr>
              <p:cNvPr id="120" name="Rectangle 119"/>
              <p:cNvSpPr/>
              <p:nvPr/>
            </p:nvSpPr>
            <p:spPr>
              <a:xfrm>
                <a:off x="4641822" y="3141117"/>
                <a:ext cx="1356579" cy="67146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29" name="Group 28"/>
          <p:cNvGrpSpPr/>
          <p:nvPr/>
        </p:nvGrpSpPr>
        <p:grpSpPr>
          <a:xfrm>
            <a:off x="3464414" y="3829709"/>
            <a:ext cx="5552148" cy="690520"/>
            <a:chOff x="3464414" y="3635920"/>
            <a:chExt cx="5552148" cy="690520"/>
          </a:xfrm>
        </p:grpSpPr>
        <p:grpSp>
          <p:nvGrpSpPr>
            <p:cNvPr id="98" name="Group 97"/>
            <p:cNvGrpSpPr/>
            <p:nvPr/>
          </p:nvGrpSpPr>
          <p:grpSpPr>
            <a:xfrm>
              <a:off x="3464414" y="3635920"/>
              <a:ext cx="1361103" cy="690520"/>
              <a:chOff x="2943588" y="4186786"/>
              <a:chExt cx="1361103" cy="690520"/>
            </a:xfrm>
          </p:grpSpPr>
          <p:pic>
            <p:nvPicPr>
              <p:cNvPr id="99" name="Picture 98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5846" t="8508" r="42009" b="90128"/>
              <a:stretch/>
            </p:blipFill>
            <p:spPr>
              <a:xfrm>
                <a:off x="2943588" y="4186786"/>
                <a:ext cx="1356920" cy="690520"/>
              </a:xfrm>
              <a:prstGeom prst="rect">
                <a:avLst/>
              </a:prstGeom>
            </p:spPr>
          </p:pic>
          <p:sp>
            <p:nvSpPr>
              <p:cNvPr id="111" name="Rectangle 110"/>
              <p:cNvSpPr/>
              <p:nvPr/>
            </p:nvSpPr>
            <p:spPr>
              <a:xfrm>
                <a:off x="2948112" y="4194315"/>
                <a:ext cx="1356579" cy="67146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21" name="Group 120"/>
            <p:cNvGrpSpPr/>
            <p:nvPr/>
          </p:nvGrpSpPr>
          <p:grpSpPr>
            <a:xfrm>
              <a:off x="4871701" y="3644697"/>
              <a:ext cx="1356579" cy="672967"/>
              <a:chOff x="4488655" y="4091914"/>
              <a:chExt cx="1356579" cy="672967"/>
            </a:xfrm>
          </p:grpSpPr>
          <p:pic>
            <p:nvPicPr>
              <p:cNvPr id="122" name="Picture 121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197" t="33963" r="41664" b="64710"/>
              <a:stretch/>
            </p:blipFill>
            <p:spPr>
              <a:xfrm>
                <a:off x="4491037" y="4093369"/>
                <a:ext cx="1352551" cy="671512"/>
              </a:xfrm>
              <a:prstGeom prst="rect">
                <a:avLst/>
              </a:prstGeom>
            </p:spPr>
          </p:pic>
          <p:sp>
            <p:nvSpPr>
              <p:cNvPr id="136" name="Rectangle 135"/>
              <p:cNvSpPr/>
              <p:nvPr/>
            </p:nvSpPr>
            <p:spPr>
              <a:xfrm>
                <a:off x="4488655" y="4091914"/>
                <a:ext cx="1356579" cy="67146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43" name="Group 142"/>
            <p:cNvGrpSpPr/>
            <p:nvPr/>
          </p:nvGrpSpPr>
          <p:grpSpPr>
            <a:xfrm>
              <a:off x="7659983" y="3645448"/>
              <a:ext cx="1356579" cy="671465"/>
              <a:chOff x="7596595" y="3830574"/>
              <a:chExt cx="1356579" cy="671465"/>
            </a:xfrm>
          </p:grpSpPr>
          <p:pic>
            <p:nvPicPr>
              <p:cNvPr id="144" name="Picture 143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5566" t="88488" r="42303" b="10201"/>
              <a:stretch/>
            </p:blipFill>
            <p:spPr>
              <a:xfrm>
                <a:off x="7600950" y="3833412"/>
                <a:ext cx="1347788" cy="663690"/>
              </a:xfrm>
              <a:prstGeom prst="rect">
                <a:avLst/>
              </a:prstGeom>
            </p:spPr>
          </p:pic>
          <p:sp>
            <p:nvSpPr>
              <p:cNvPr id="145" name="Rectangle 144"/>
              <p:cNvSpPr/>
              <p:nvPr/>
            </p:nvSpPr>
            <p:spPr>
              <a:xfrm>
                <a:off x="7596595" y="3830574"/>
                <a:ext cx="1356579" cy="67146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52" name="Group 151"/>
            <p:cNvGrpSpPr/>
            <p:nvPr/>
          </p:nvGrpSpPr>
          <p:grpSpPr>
            <a:xfrm>
              <a:off x="6269824" y="3643826"/>
              <a:ext cx="1356579" cy="674709"/>
              <a:chOff x="6038386" y="4028261"/>
              <a:chExt cx="1356579" cy="674709"/>
            </a:xfrm>
          </p:grpSpPr>
          <p:pic>
            <p:nvPicPr>
              <p:cNvPr id="153" name="Picture 152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471" t="59976" r="41406" b="38698"/>
              <a:stretch/>
            </p:blipFill>
            <p:spPr>
              <a:xfrm>
                <a:off x="6043612" y="4031456"/>
                <a:ext cx="1343025" cy="671514"/>
              </a:xfrm>
              <a:prstGeom prst="rect">
                <a:avLst/>
              </a:prstGeom>
            </p:spPr>
          </p:pic>
          <p:sp>
            <p:nvSpPr>
              <p:cNvPr id="154" name="Rectangle 153"/>
              <p:cNvSpPr/>
              <p:nvPr/>
            </p:nvSpPr>
            <p:spPr>
              <a:xfrm>
                <a:off x="6038386" y="4028261"/>
                <a:ext cx="1356579" cy="67146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30" name="Group 29"/>
          <p:cNvGrpSpPr/>
          <p:nvPr/>
        </p:nvGrpSpPr>
        <p:grpSpPr>
          <a:xfrm>
            <a:off x="3464414" y="4767517"/>
            <a:ext cx="5544337" cy="694060"/>
            <a:chOff x="3499723" y="4552288"/>
            <a:chExt cx="5544337" cy="694060"/>
          </a:xfrm>
        </p:grpSpPr>
        <p:grpSp>
          <p:nvGrpSpPr>
            <p:cNvPr id="112" name="Group 111"/>
            <p:cNvGrpSpPr/>
            <p:nvPr/>
          </p:nvGrpSpPr>
          <p:grpSpPr>
            <a:xfrm>
              <a:off x="3499723" y="4552288"/>
              <a:ext cx="1360720" cy="694060"/>
              <a:chOff x="3086699" y="5069544"/>
              <a:chExt cx="1360720" cy="694060"/>
            </a:xfrm>
          </p:grpSpPr>
          <p:pic>
            <p:nvPicPr>
              <p:cNvPr id="113" name="Picture 112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5831" t="8427" r="52018" b="90202"/>
              <a:stretch/>
            </p:blipFill>
            <p:spPr>
              <a:xfrm>
                <a:off x="3086699" y="5069544"/>
                <a:ext cx="1360720" cy="694060"/>
              </a:xfrm>
              <a:prstGeom prst="rect">
                <a:avLst/>
              </a:prstGeom>
            </p:spPr>
          </p:pic>
          <p:sp>
            <p:nvSpPr>
              <p:cNvPr id="114" name="Rectangle 113"/>
              <p:cNvSpPr/>
              <p:nvPr/>
            </p:nvSpPr>
            <p:spPr>
              <a:xfrm>
                <a:off x="3088444" y="5080234"/>
                <a:ext cx="1356579" cy="67146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37" name="Group 136"/>
            <p:cNvGrpSpPr/>
            <p:nvPr/>
          </p:nvGrpSpPr>
          <p:grpSpPr>
            <a:xfrm>
              <a:off x="4899199" y="4563586"/>
              <a:ext cx="1356579" cy="671465"/>
              <a:chOff x="4488655" y="5064837"/>
              <a:chExt cx="1356579" cy="671465"/>
            </a:xfrm>
          </p:grpSpPr>
          <p:pic>
            <p:nvPicPr>
              <p:cNvPr id="138" name="Picture 137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5978" t="33949" r="51899" b="64743"/>
              <a:stretch/>
            </p:blipFill>
            <p:spPr>
              <a:xfrm>
                <a:off x="4493419" y="5069681"/>
                <a:ext cx="1343332" cy="661988"/>
              </a:xfrm>
              <a:prstGeom prst="rect">
                <a:avLst/>
              </a:prstGeom>
            </p:spPr>
          </p:pic>
          <p:sp>
            <p:nvSpPr>
              <p:cNvPr id="139" name="Rectangle 138"/>
              <p:cNvSpPr/>
              <p:nvPr/>
            </p:nvSpPr>
            <p:spPr>
              <a:xfrm>
                <a:off x="4488655" y="5064837"/>
                <a:ext cx="1356579" cy="67146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46" name="Group 145"/>
            <p:cNvGrpSpPr/>
            <p:nvPr/>
          </p:nvGrpSpPr>
          <p:grpSpPr>
            <a:xfrm>
              <a:off x="7687481" y="4563340"/>
              <a:ext cx="1356579" cy="671957"/>
              <a:chOff x="7557177" y="5153025"/>
              <a:chExt cx="1356579" cy="671957"/>
            </a:xfrm>
          </p:grpSpPr>
          <p:pic>
            <p:nvPicPr>
              <p:cNvPr id="147" name="Picture 146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5451" t="88843" r="52411" b="9840"/>
              <a:stretch/>
            </p:blipFill>
            <p:spPr>
              <a:xfrm>
                <a:off x="7560649" y="5153025"/>
                <a:ext cx="1352370" cy="666750"/>
              </a:xfrm>
              <a:prstGeom prst="rect">
                <a:avLst/>
              </a:prstGeom>
            </p:spPr>
          </p:pic>
          <p:sp>
            <p:nvSpPr>
              <p:cNvPr id="148" name="Rectangle 147"/>
              <p:cNvSpPr/>
              <p:nvPr/>
            </p:nvSpPr>
            <p:spPr>
              <a:xfrm>
                <a:off x="7557177" y="5153517"/>
                <a:ext cx="1356579" cy="67146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55" name="Group 154"/>
            <p:cNvGrpSpPr/>
            <p:nvPr/>
          </p:nvGrpSpPr>
          <p:grpSpPr>
            <a:xfrm>
              <a:off x="6297322" y="4563586"/>
              <a:ext cx="1356579" cy="671465"/>
              <a:chOff x="6129113" y="5152678"/>
              <a:chExt cx="1356579" cy="671465"/>
            </a:xfrm>
          </p:grpSpPr>
          <p:pic>
            <p:nvPicPr>
              <p:cNvPr id="156" name="Picture 155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6424" t="60163" r="51440" b="38539"/>
              <a:stretch/>
            </p:blipFill>
            <p:spPr>
              <a:xfrm>
                <a:off x="6129920" y="5162807"/>
                <a:ext cx="1351230" cy="656968"/>
              </a:xfrm>
              <a:prstGeom prst="rect">
                <a:avLst/>
              </a:prstGeom>
            </p:spPr>
          </p:pic>
          <p:sp>
            <p:nvSpPr>
              <p:cNvPr id="157" name="Rectangle 156"/>
              <p:cNvSpPr/>
              <p:nvPr/>
            </p:nvSpPr>
            <p:spPr>
              <a:xfrm>
                <a:off x="6129113" y="5152678"/>
                <a:ext cx="1356579" cy="67146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37" name="Group 36"/>
          <p:cNvGrpSpPr/>
          <p:nvPr/>
        </p:nvGrpSpPr>
        <p:grpSpPr>
          <a:xfrm>
            <a:off x="3464414" y="5708864"/>
            <a:ext cx="5542266" cy="671465"/>
            <a:chOff x="3469860" y="5708864"/>
            <a:chExt cx="5542266" cy="671465"/>
          </a:xfrm>
        </p:grpSpPr>
        <p:grpSp>
          <p:nvGrpSpPr>
            <p:cNvPr id="115" name="Group 114"/>
            <p:cNvGrpSpPr/>
            <p:nvPr/>
          </p:nvGrpSpPr>
          <p:grpSpPr>
            <a:xfrm>
              <a:off x="3469860" y="5708864"/>
              <a:ext cx="1356579" cy="671465"/>
              <a:chOff x="2918573" y="5893418"/>
              <a:chExt cx="1356579" cy="671465"/>
            </a:xfrm>
          </p:grpSpPr>
          <p:pic>
            <p:nvPicPr>
              <p:cNvPr id="116" name="Picture 115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704" t="8427" r="49163" b="90265"/>
              <a:stretch/>
            </p:blipFill>
            <p:spPr>
              <a:xfrm>
                <a:off x="2924175" y="5898065"/>
                <a:ext cx="1349376" cy="662170"/>
              </a:xfrm>
              <a:prstGeom prst="rect">
                <a:avLst/>
              </a:prstGeom>
            </p:spPr>
          </p:pic>
          <p:sp>
            <p:nvSpPr>
              <p:cNvPr id="117" name="Rectangle 116"/>
              <p:cNvSpPr/>
              <p:nvPr/>
            </p:nvSpPr>
            <p:spPr>
              <a:xfrm>
                <a:off x="2918573" y="5893418"/>
                <a:ext cx="1356579" cy="67146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40" name="Group 139"/>
            <p:cNvGrpSpPr/>
            <p:nvPr/>
          </p:nvGrpSpPr>
          <p:grpSpPr>
            <a:xfrm>
              <a:off x="4867265" y="5708864"/>
              <a:ext cx="1356579" cy="671465"/>
              <a:chOff x="4405707" y="5883130"/>
              <a:chExt cx="1356579" cy="671465"/>
            </a:xfrm>
          </p:grpSpPr>
          <p:pic>
            <p:nvPicPr>
              <p:cNvPr id="141" name="Picture 140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786" t="33878" r="49089" b="64796"/>
              <a:stretch/>
            </p:blipFill>
            <p:spPr>
              <a:xfrm>
                <a:off x="4411861" y="5883275"/>
                <a:ext cx="1344270" cy="671320"/>
              </a:xfrm>
              <a:prstGeom prst="rect">
                <a:avLst/>
              </a:prstGeom>
            </p:spPr>
          </p:pic>
          <p:sp>
            <p:nvSpPr>
              <p:cNvPr id="142" name="Rectangle 141"/>
              <p:cNvSpPr/>
              <p:nvPr/>
            </p:nvSpPr>
            <p:spPr>
              <a:xfrm>
                <a:off x="4405707" y="5883130"/>
                <a:ext cx="1356579" cy="67146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49" name="Group 148"/>
            <p:cNvGrpSpPr/>
            <p:nvPr/>
          </p:nvGrpSpPr>
          <p:grpSpPr>
            <a:xfrm>
              <a:off x="7655547" y="5708864"/>
              <a:ext cx="1356579" cy="671465"/>
              <a:chOff x="7516463" y="5969292"/>
              <a:chExt cx="1356579" cy="671465"/>
            </a:xfrm>
          </p:grpSpPr>
          <p:pic>
            <p:nvPicPr>
              <p:cNvPr id="150" name="Picture 149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204" t="88879" r="49670" b="9810"/>
              <a:stretch/>
            </p:blipFill>
            <p:spPr>
              <a:xfrm>
                <a:off x="7522302" y="5969292"/>
                <a:ext cx="1344900" cy="663283"/>
              </a:xfrm>
              <a:prstGeom prst="rect">
                <a:avLst/>
              </a:prstGeom>
            </p:spPr>
          </p:pic>
          <p:sp>
            <p:nvSpPr>
              <p:cNvPr id="151" name="Rectangle 150"/>
              <p:cNvSpPr/>
              <p:nvPr/>
            </p:nvSpPr>
            <p:spPr>
              <a:xfrm>
                <a:off x="7516463" y="5969292"/>
                <a:ext cx="1356579" cy="67146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58" name="Group 157"/>
            <p:cNvGrpSpPr/>
            <p:nvPr/>
          </p:nvGrpSpPr>
          <p:grpSpPr>
            <a:xfrm>
              <a:off x="6265388" y="5708864"/>
              <a:ext cx="1356579" cy="671465"/>
              <a:chOff x="5921338" y="6029958"/>
              <a:chExt cx="1356579" cy="671465"/>
            </a:xfrm>
          </p:grpSpPr>
          <p:pic>
            <p:nvPicPr>
              <p:cNvPr id="159" name="Picture 158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180" t="60129" r="48682" b="38567"/>
              <a:stretch/>
            </p:blipFill>
            <p:spPr>
              <a:xfrm>
                <a:off x="5921376" y="6035490"/>
                <a:ext cx="1352550" cy="660400"/>
              </a:xfrm>
              <a:prstGeom prst="rect">
                <a:avLst/>
              </a:prstGeom>
            </p:spPr>
          </p:pic>
          <p:sp>
            <p:nvSpPr>
              <p:cNvPr id="160" name="Rectangle 159"/>
              <p:cNvSpPr/>
              <p:nvPr/>
            </p:nvSpPr>
            <p:spPr>
              <a:xfrm>
                <a:off x="5921338" y="6029958"/>
                <a:ext cx="1356579" cy="671465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170" name="Rectangle 169"/>
          <p:cNvSpPr/>
          <p:nvPr/>
        </p:nvSpPr>
        <p:spPr>
          <a:xfrm>
            <a:off x="3357800" y="1694701"/>
            <a:ext cx="5643040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b="1" dirty="0" smtClean="0"/>
              <a:t>  10120.305:       10655.669:          13869.326:       14077.447:        15072.154:        13801.326:   14319.740:      14075.740</a:t>
            </a:r>
          </a:p>
        </p:txBody>
      </p:sp>
      <p:sp>
        <p:nvSpPr>
          <p:cNvPr id="171" name="Rectangle 170"/>
          <p:cNvSpPr/>
          <p:nvPr/>
        </p:nvSpPr>
        <p:spPr>
          <a:xfrm>
            <a:off x="3438422" y="2643340"/>
            <a:ext cx="5643040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b="1" dirty="0" smtClean="0"/>
              <a:t>8612.749:           9032.042:           10481.012:       9134.477:       9587.891:        10212.669:        9620.841:       9927.669</a:t>
            </a:r>
          </a:p>
        </p:txBody>
      </p:sp>
      <p:sp>
        <p:nvSpPr>
          <p:cNvPr id="172" name="Rectangle 171"/>
          <p:cNvSpPr/>
          <p:nvPr/>
        </p:nvSpPr>
        <p:spPr>
          <a:xfrm>
            <a:off x="3464414" y="3586972"/>
            <a:ext cx="5643040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b="1" dirty="0" smtClean="0"/>
              <a:t>9772.719:        11752.962:       14107.205:       14398.447:       15147.690:        15006.861:        16053.983:     14404.447</a:t>
            </a:r>
          </a:p>
        </p:txBody>
      </p:sp>
      <p:sp>
        <p:nvSpPr>
          <p:cNvPr id="173" name="Rectangle 172"/>
          <p:cNvSpPr/>
          <p:nvPr/>
        </p:nvSpPr>
        <p:spPr>
          <a:xfrm>
            <a:off x="3466655" y="4498133"/>
            <a:ext cx="5643040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b="1" dirty="0" smtClean="0"/>
              <a:t>9301.891:        9395.062:          9535.770:          9445.355:         9643.941:            9539.184:           10535.770:     7980.820</a:t>
            </a:r>
          </a:p>
        </p:txBody>
      </p:sp>
      <p:sp>
        <p:nvSpPr>
          <p:cNvPr id="174" name="Rectangle 173"/>
          <p:cNvSpPr/>
          <p:nvPr/>
        </p:nvSpPr>
        <p:spPr>
          <a:xfrm>
            <a:off x="3464414" y="5483282"/>
            <a:ext cx="5643040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b="1" dirty="0" smtClean="0"/>
              <a:t>8882.648:         9298.941:         9914.184:          9209.062:          10045.305:        9768.184:         10602.669:     9946.134</a:t>
            </a:r>
          </a:p>
        </p:txBody>
      </p:sp>
      <p:sp>
        <p:nvSpPr>
          <p:cNvPr id="175" name="Rectangle 174"/>
          <p:cNvSpPr/>
          <p:nvPr/>
        </p:nvSpPr>
        <p:spPr>
          <a:xfrm>
            <a:off x="3464414" y="6439173"/>
            <a:ext cx="564304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b="1" dirty="0" smtClean="0"/>
              <a:t>9468.012:        10084.841:          9311.891:       10577.255:       9716.184:         10532.598:       9826.719:        10161.790</a:t>
            </a:r>
            <a:endParaRPr lang="en-US" sz="900" b="1" dirty="0"/>
          </a:p>
          <a:p>
            <a:endParaRPr lang="en-US" sz="900" b="1" dirty="0"/>
          </a:p>
        </p:txBody>
      </p:sp>
      <p:sp>
        <p:nvSpPr>
          <p:cNvPr id="107" name="TextBox 106"/>
          <p:cNvSpPr txBox="1"/>
          <p:nvPr/>
        </p:nvSpPr>
        <p:spPr>
          <a:xfrm>
            <a:off x="4018280" y="621292"/>
            <a:ext cx="45736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2’                      10’                     30’                    60’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47659245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-41032" y="57891"/>
            <a:ext cx="12192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 smtClean="0"/>
              <a:t>Unaltered Chemokine Blots</a:t>
            </a:r>
            <a:endParaRPr lang="en-US" sz="2400" b="1" dirty="0"/>
          </a:p>
        </p:txBody>
      </p:sp>
      <p:grpSp>
        <p:nvGrpSpPr>
          <p:cNvPr id="4" name="Group 3"/>
          <p:cNvGrpSpPr/>
          <p:nvPr/>
        </p:nvGrpSpPr>
        <p:grpSpPr>
          <a:xfrm>
            <a:off x="1005589" y="585463"/>
            <a:ext cx="4420334" cy="6078177"/>
            <a:chOff x="899341" y="640123"/>
            <a:chExt cx="4420334" cy="6078177"/>
          </a:xfrm>
        </p:grpSpPr>
        <p:pic>
          <p:nvPicPr>
            <p:cNvPr id="57" name="Picture 56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210" t="84111" r="38000" b="3099"/>
            <a:stretch/>
          </p:blipFill>
          <p:spPr>
            <a:xfrm>
              <a:off x="899341" y="5266688"/>
              <a:ext cx="3942318" cy="1451612"/>
            </a:xfrm>
            <a:prstGeom prst="rect">
              <a:avLst/>
            </a:prstGeom>
          </p:spPr>
        </p:pic>
        <p:pic>
          <p:nvPicPr>
            <p:cNvPr id="59" name="Picture 58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210" t="55810" r="38000" b="31004"/>
            <a:stretch/>
          </p:blipFill>
          <p:spPr>
            <a:xfrm>
              <a:off x="899341" y="3680295"/>
              <a:ext cx="3942319" cy="1496621"/>
            </a:xfrm>
            <a:prstGeom prst="rect">
              <a:avLst/>
            </a:prstGeom>
          </p:spPr>
        </p:pic>
        <p:pic>
          <p:nvPicPr>
            <p:cNvPr id="60" name="Picture 59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210" t="29791" r="38000" b="57473"/>
            <a:stretch/>
          </p:blipFill>
          <p:spPr>
            <a:xfrm>
              <a:off x="899341" y="2145006"/>
              <a:ext cx="3942319" cy="1445517"/>
            </a:xfrm>
            <a:prstGeom prst="rect">
              <a:avLst/>
            </a:prstGeom>
          </p:spPr>
        </p:pic>
        <p:pic>
          <p:nvPicPr>
            <p:cNvPr id="61" name="Picture 60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210" t="4106" r="38000" b="83426"/>
            <a:stretch/>
          </p:blipFill>
          <p:spPr>
            <a:xfrm>
              <a:off x="899341" y="640123"/>
              <a:ext cx="3942318" cy="1415111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4900970" y="1163012"/>
              <a:ext cx="3593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2’</a:t>
              </a:r>
              <a:endParaRPr lang="en-US" b="1" dirty="0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4841659" y="2684871"/>
              <a:ext cx="4780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10’</a:t>
              </a:r>
              <a:endParaRPr lang="en-US" b="1" dirty="0"/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4841659" y="4243939"/>
              <a:ext cx="4780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30’</a:t>
              </a:r>
              <a:endParaRPr lang="en-US" b="1" dirty="0"/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4841659" y="5807828"/>
              <a:ext cx="4780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60’</a:t>
              </a:r>
              <a:endParaRPr lang="en-US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7275226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71188"/>
            <a:ext cx="7560001" cy="6048001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130406"/>
            <a:ext cx="12192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 smtClean="0"/>
              <a:t>Unaltered Western Blot for CD9, Histone H3, Jak2, Pan </a:t>
            </a:r>
            <a:r>
              <a:rPr lang="en-US" sz="2400" b="1" dirty="0" err="1" smtClean="0"/>
              <a:t>Ras</a:t>
            </a:r>
            <a:r>
              <a:rPr lang="en-US" sz="2400" b="1" dirty="0" smtClean="0"/>
              <a:t> and Hsp70</a:t>
            </a:r>
            <a:endParaRPr lang="en-US" sz="2400" b="1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10" r="51064" b="70780"/>
          <a:stretch/>
        </p:blipFill>
        <p:spPr>
          <a:xfrm>
            <a:off x="7679062" y="671188"/>
            <a:ext cx="2171701" cy="176721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282" t="33387" r="41867" b="28731"/>
          <a:stretch/>
        </p:blipFill>
        <p:spPr>
          <a:xfrm rot="5400000">
            <a:off x="8338830" y="1835782"/>
            <a:ext cx="971550" cy="229108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638" t="28275" r="27755" b="26840"/>
          <a:stretch/>
        </p:blipFill>
        <p:spPr>
          <a:xfrm rot="5400000">
            <a:off x="8522024" y="2681288"/>
            <a:ext cx="1028700" cy="271462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158" t="31546" r="10368" b="28136"/>
          <a:stretch/>
        </p:blipFill>
        <p:spPr>
          <a:xfrm rot="5400000">
            <a:off x="8426773" y="3948113"/>
            <a:ext cx="942975" cy="24384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805" t="11795" r="3256" b="15730"/>
          <a:stretch/>
        </p:blipFill>
        <p:spPr>
          <a:xfrm>
            <a:off x="7759676" y="5664355"/>
            <a:ext cx="2126842" cy="1170959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7872153" y="5664355"/>
            <a:ext cx="139493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 CM61     CF49   HM59</a:t>
            </a:r>
            <a:endParaRPr lang="en-US" sz="105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9512139" y="5724525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CD9</a:t>
            </a:r>
            <a:endParaRPr lang="en-US" sz="1100" b="1" dirty="0"/>
          </a:p>
        </p:txBody>
      </p:sp>
      <p:cxnSp>
        <p:nvCxnSpPr>
          <p:cNvPr id="14" name="Straight Connector 13"/>
          <p:cNvCxnSpPr/>
          <p:nvPr/>
        </p:nvCxnSpPr>
        <p:spPr>
          <a:xfrm>
            <a:off x="9637913" y="6367549"/>
            <a:ext cx="18306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9637913" y="6129251"/>
            <a:ext cx="18306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9637913" y="6796777"/>
            <a:ext cx="18306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7763996" y="6367549"/>
            <a:ext cx="18306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7763996" y="6129251"/>
            <a:ext cx="18306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9564975" y="6585133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15</a:t>
            </a:r>
            <a:endParaRPr lang="en-US" sz="1050" b="1" dirty="0"/>
          </a:p>
        </p:txBody>
      </p:sp>
      <p:cxnSp>
        <p:nvCxnSpPr>
          <p:cNvPr id="21" name="Straight Connector 20"/>
          <p:cNvCxnSpPr/>
          <p:nvPr/>
        </p:nvCxnSpPr>
        <p:spPr>
          <a:xfrm>
            <a:off x="9637913" y="6585133"/>
            <a:ext cx="18306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7763996" y="6585133"/>
            <a:ext cx="18306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9568181" y="6381441"/>
            <a:ext cx="32252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25</a:t>
            </a:r>
            <a:endParaRPr lang="en-US" sz="105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9568181" y="6156808"/>
            <a:ext cx="32252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35</a:t>
            </a:r>
            <a:endParaRPr lang="en-US" sz="105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9568181" y="5918271"/>
            <a:ext cx="32252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40</a:t>
            </a:r>
            <a:endParaRPr lang="en-US" sz="1050" b="1" dirty="0"/>
          </a:p>
        </p:txBody>
      </p:sp>
    </p:spTree>
    <p:extLst>
      <p:ext uri="{BB962C8B-B14F-4D97-AF65-F5344CB8AC3E}">
        <p14:creationId xmlns:p14="http://schemas.microsoft.com/office/powerpoint/2010/main" val="32565996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90" t="41102" b="33547"/>
          <a:stretch/>
        </p:blipFill>
        <p:spPr>
          <a:xfrm>
            <a:off x="3463538" y="3601385"/>
            <a:ext cx="5264926" cy="38959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83" t="59121" b="31557"/>
          <a:stretch/>
        </p:blipFill>
        <p:spPr>
          <a:xfrm>
            <a:off x="3463537" y="2852057"/>
            <a:ext cx="5264926" cy="391885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3463536" y="2852057"/>
            <a:ext cx="5264927" cy="39188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 rot="18360394">
            <a:off x="3483280" y="2269119"/>
            <a:ext cx="10102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lone #1</a:t>
            </a:r>
            <a:endParaRPr lang="en-US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8775534" y="3741643"/>
            <a:ext cx="10855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WB: GAPDH</a:t>
            </a:r>
            <a:endParaRPr lang="en-US" sz="1400" b="1" dirty="0"/>
          </a:p>
        </p:txBody>
      </p:sp>
      <p:sp>
        <p:nvSpPr>
          <p:cNvPr id="15" name="TextBox 14"/>
          <p:cNvSpPr txBox="1"/>
          <p:nvPr/>
        </p:nvSpPr>
        <p:spPr>
          <a:xfrm rot="18360394">
            <a:off x="4172888" y="2241835"/>
            <a:ext cx="957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lone#2</a:t>
            </a:r>
            <a:endParaRPr lang="en-US" b="1" dirty="0"/>
          </a:p>
        </p:txBody>
      </p:sp>
      <p:sp>
        <p:nvSpPr>
          <p:cNvPr id="16" name="TextBox 15"/>
          <p:cNvSpPr txBox="1"/>
          <p:nvPr/>
        </p:nvSpPr>
        <p:spPr>
          <a:xfrm rot="18360394">
            <a:off x="4836046" y="2241835"/>
            <a:ext cx="957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lone#3</a:t>
            </a:r>
            <a:endParaRPr lang="en-US" b="1" dirty="0"/>
          </a:p>
        </p:txBody>
      </p:sp>
      <p:sp>
        <p:nvSpPr>
          <p:cNvPr id="17" name="TextBox 16"/>
          <p:cNvSpPr txBox="1"/>
          <p:nvPr/>
        </p:nvSpPr>
        <p:spPr>
          <a:xfrm rot="18360394">
            <a:off x="5499204" y="2241835"/>
            <a:ext cx="957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lone#4</a:t>
            </a:r>
            <a:endParaRPr lang="en-US" b="1" dirty="0"/>
          </a:p>
        </p:txBody>
      </p:sp>
      <p:sp>
        <p:nvSpPr>
          <p:cNvPr id="18" name="TextBox 17"/>
          <p:cNvSpPr txBox="1"/>
          <p:nvPr/>
        </p:nvSpPr>
        <p:spPr>
          <a:xfrm rot="18360394">
            <a:off x="6162362" y="2241835"/>
            <a:ext cx="957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lone#5</a:t>
            </a:r>
            <a:endParaRPr lang="en-US" b="1" dirty="0"/>
          </a:p>
        </p:txBody>
      </p:sp>
      <p:sp>
        <p:nvSpPr>
          <p:cNvPr id="19" name="TextBox 18"/>
          <p:cNvSpPr txBox="1"/>
          <p:nvPr/>
        </p:nvSpPr>
        <p:spPr>
          <a:xfrm rot="18360394">
            <a:off x="6825520" y="2241835"/>
            <a:ext cx="957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lone#6</a:t>
            </a:r>
            <a:endParaRPr lang="en-US" b="1" dirty="0"/>
          </a:p>
        </p:txBody>
      </p:sp>
      <p:sp>
        <p:nvSpPr>
          <p:cNvPr id="20" name="TextBox 19"/>
          <p:cNvSpPr txBox="1"/>
          <p:nvPr/>
        </p:nvSpPr>
        <p:spPr>
          <a:xfrm rot="18360394">
            <a:off x="7488678" y="2241835"/>
            <a:ext cx="957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lone#7</a:t>
            </a:r>
            <a:endParaRPr lang="en-US" b="1" dirty="0"/>
          </a:p>
        </p:txBody>
      </p:sp>
      <p:sp>
        <p:nvSpPr>
          <p:cNvPr id="21" name="TextBox 20"/>
          <p:cNvSpPr txBox="1"/>
          <p:nvPr/>
        </p:nvSpPr>
        <p:spPr>
          <a:xfrm rot="18360394">
            <a:off x="8185562" y="2241835"/>
            <a:ext cx="889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ontrol</a:t>
            </a:r>
            <a:endParaRPr lang="en-US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8775534" y="2925232"/>
            <a:ext cx="10990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WB: TSG101</a:t>
            </a:r>
            <a:endParaRPr lang="en-US" sz="1400" b="1" dirty="0"/>
          </a:p>
        </p:txBody>
      </p:sp>
      <p:sp>
        <p:nvSpPr>
          <p:cNvPr id="24" name="Rectangle 23"/>
          <p:cNvSpPr/>
          <p:nvPr/>
        </p:nvSpPr>
        <p:spPr>
          <a:xfrm>
            <a:off x="3463536" y="3601384"/>
            <a:ext cx="5264927" cy="39188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3450940" y="3998443"/>
            <a:ext cx="531908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11427.347: 4062.782:  5244.497:     7050.74:     6516.447:     7104.104:   8721.882:</a:t>
            </a:r>
            <a:r>
              <a:rPr lang="en-US" sz="1050" b="1" dirty="0"/>
              <a:t>	4615.903</a:t>
            </a:r>
          </a:p>
        </p:txBody>
      </p:sp>
      <p:sp>
        <p:nvSpPr>
          <p:cNvPr id="25" name="Rectangle 24"/>
          <p:cNvSpPr/>
          <p:nvPr/>
        </p:nvSpPr>
        <p:spPr>
          <a:xfrm>
            <a:off x="3450940" y="3246867"/>
            <a:ext cx="6096000" cy="253916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050" b="1" dirty="0" smtClean="0"/>
              <a:t>1013.205:   2468.782:  5676.439:      848.648:    7111.296:     5568.225:    4111.317:  </a:t>
            </a:r>
            <a:r>
              <a:rPr lang="en-US" sz="1050" b="1" dirty="0"/>
              <a:t>	2129.276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0" y="130406"/>
            <a:ext cx="12192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 smtClean="0"/>
              <a:t>TSG101 Knock Down in CM61 cell lines</a:t>
            </a:r>
            <a:endParaRPr lang="en-US" sz="2400" b="1" dirty="0"/>
          </a:p>
        </p:txBody>
      </p:sp>
      <p:grpSp>
        <p:nvGrpSpPr>
          <p:cNvPr id="26" name="Group 25"/>
          <p:cNvGrpSpPr/>
          <p:nvPr/>
        </p:nvGrpSpPr>
        <p:grpSpPr>
          <a:xfrm flipH="1">
            <a:off x="3072258" y="2746833"/>
            <a:ext cx="489235" cy="596973"/>
            <a:chOff x="4914282" y="2706758"/>
            <a:chExt cx="397456" cy="596973"/>
          </a:xfrm>
        </p:grpSpPr>
        <p:sp>
          <p:nvSpPr>
            <p:cNvPr id="28" name="TextBox 27"/>
            <p:cNvSpPr txBox="1"/>
            <p:nvPr/>
          </p:nvSpPr>
          <p:spPr>
            <a:xfrm>
              <a:off x="4914282" y="2934399"/>
              <a:ext cx="3974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40-</a:t>
              </a:r>
              <a:endParaRPr lang="en-US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4914282" y="2706758"/>
              <a:ext cx="3974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50-</a:t>
              </a:r>
              <a:endParaRPr lang="en-US" dirty="0"/>
            </a:p>
          </p:txBody>
        </p:sp>
      </p:grpSp>
      <p:grpSp>
        <p:nvGrpSpPr>
          <p:cNvPr id="38" name="Group 37"/>
          <p:cNvGrpSpPr/>
          <p:nvPr/>
        </p:nvGrpSpPr>
        <p:grpSpPr>
          <a:xfrm flipH="1">
            <a:off x="3060703" y="3446814"/>
            <a:ext cx="489236" cy="731803"/>
            <a:chOff x="4914281" y="2934399"/>
            <a:chExt cx="397457" cy="731803"/>
          </a:xfrm>
        </p:grpSpPr>
        <p:sp>
          <p:nvSpPr>
            <p:cNvPr id="40" name="TextBox 39"/>
            <p:cNvSpPr txBox="1"/>
            <p:nvPr/>
          </p:nvSpPr>
          <p:spPr>
            <a:xfrm>
              <a:off x="4914282" y="2934399"/>
              <a:ext cx="3974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40-</a:t>
              </a:r>
              <a:endParaRPr lang="en-US" dirty="0"/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4914281" y="3296870"/>
              <a:ext cx="3974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35-</a:t>
              </a:r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16930548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7844" y="2431916"/>
            <a:ext cx="4571800" cy="3212878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 rot="18360394">
            <a:off x="1172094" y="1966052"/>
            <a:ext cx="8274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Clone #1</a:t>
            </a:r>
            <a:endParaRPr lang="en-US" sz="1400" b="1" dirty="0"/>
          </a:p>
        </p:txBody>
      </p:sp>
      <p:sp>
        <p:nvSpPr>
          <p:cNvPr id="6" name="TextBox 5"/>
          <p:cNvSpPr txBox="1"/>
          <p:nvPr/>
        </p:nvSpPr>
        <p:spPr>
          <a:xfrm rot="18360394">
            <a:off x="1698147" y="1982262"/>
            <a:ext cx="7873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Clone#2</a:t>
            </a:r>
            <a:endParaRPr lang="en-US" sz="1400" b="1" dirty="0"/>
          </a:p>
        </p:txBody>
      </p:sp>
      <p:sp>
        <p:nvSpPr>
          <p:cNvPr id="7" name="TextBox 6"/>
          <p:cNvSpPr txBox="1"/>
          <p:nvPr/>
        </p:nvSpPr>
        <p:spPr>
          <a:xfrm rot="18360394">
            <a:off x="2204162" y="1982262"/>
            <a:ext cx="7873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Clone#3</a:t>
            </a:r>
            <a:endParaRPr lang="en-US" sz="1400" b="1" dirty="0"/>
          </a:p>
        </p:txBody>
      </p:sp>
      <p:sp>
        <p:nvSpPr>
          <p:cNvPr id="8" name="TextBox 7"/>
          <p:cNvSpPr txBox="1"/>
          <p:nvPr/>
        </p:nvSpPr>
        <p:spPr>
          <a:xfrm rot="18360394">
            <a:off x="2710177" y="1982262"/>
            <a:ext cx="7873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Clone#4</a:t>
            </a:r>
            <a:endParaRPr lang="en-US" sz="1400" b="1" dirty="0"/>
          </a:p>
        </p:txBody>
      </p:sp>
      <p:sp>
        <p:nvSpPr>
          <p:cNvPr id="9" name="TextBox 8"/>
          <p:cNvSpPr txBox="1"/>
          <p:nvPr/>
        </p:nvSpPr>
        <p:spPr>
          <a:xfrm rot="18360394">
            <a:off x="3216192" y="1982262"/>
            <a:ext cx="7873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Clone#5</a:t>
            </a:r>
            <a:endParaRPr lang="en-US" sz="1400" b="1" dirty="0"/>
          </a:p>
        </p:txBody>
      </p:sp>
      <p:sp>
        <p:nvSpPr>
          <p:cNvPr id="10" name="TextBox 9"/>
          <p:cNvSpPr txBox="1"/>
          <p:nvPr/>
        </p:nvSpPr>
        <p:spPr>
          <a:xfrm rot="18360394">
            <a:off x="3722207" y="1982262"/>
            <a:ext cx="7873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Clone#6</a:t>
            </a:r>
            <a:endParaRPr lang="en-US" sz="1400" b="1" dirty="0"/>
          </a:p>
        </p:txBody>
      </p:sp>
      <p:sp>
        <p:nvSpPr>
          <p:cNvPr id="11" name="TextBox 10"/>
          <p:cNvSpPr txBox="1"/>
          <p:nvPr/>
        </p:nvSpPr>
        <p:spPr>
          <a:xfrm rot="18360394">
            <a:off x="4228222" y="1982262"/>
            <a:ext cx="7873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Clone#7</a:t>
            </a:r>
            <a:endParaRPr lang="en-US" sz="1400" b="1" dirty="0"/>
          </a:p>
        </p:txBody>
      </p:sp>
      <p:sp>
        <p:nvSpPr>
          <p:cNvPr id="12" name="TextBox 11"/>
          <p:cNvSpPr txBox="1"/>
          <p:nvPr/>
        </p:nvSpPr>
        <p:spPr>
          <a:xfrm rot="18360394">
            <a:off x="4760208" y="2003269"/>
            <a:ext cx="7354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Control</a:t>
            </a:r>
            <a:endParaRPr lang="en-US" sz="14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5170293" y="5337017"/>
            <a:ext cx="10990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WB: TSG101</a:t>
            </a:r>
            <a:endParaRPr lang="en-US" sz="1400" b="1" dirty="0"/>
          </a:p>
        </p:txBody>
      </p:sp>
      <p:grpSp>
        <p:nvGrpSpPr>
          <p:cNvPr id="23" name="Group 22"/>
          <p:cNvGrpSpPr/>
          <p:nvPr/>
        </p:nvGrpSpPr>
        <p:grpSpPr>
          <a:xfrm flipH="1">
            <a:off x="174097" y="3686281"/>
            <a:ext cx="824948" cy="1804624"/>
            <a:chOff x="4641548" y="2285351"/>
            <a:chExt cx="670190" cy="1804624"/>
          </a:xfrm>
        </p:grpSpPr>
        <p:sp>
          <p:nvSpPr>
            <p:cNvPr id="24" name="TextBox 23"/>
            <p:cNvSpPr txBox="1"/>
            <p:nvPr/>
          </p:nvSpPr>
          <p:spPr>
            <a:xfrm>
              <a:off x="4893034" y="2285351"/>
              <a:ext cx="418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70</a:t>
              </a:r>
              <a:endParaRPr lang="en-US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4893034" y="2934399"/>
              <a:ext cx="418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40</a:t>
              </a:r>
              <a:endParaRPr lang="en-US" dirty="0"/>
            </a:p>
          </p:txBody>
        </p:sp>
        <p:grpSp>
          <p:nvGrpSpPr>
            <p:cNvPr id="26" name="Group 25"/>
            <p:cNvGrpSpPr/>
            <p:nvPr/>
          </p:nvGrpSpPr>
          <p:grpSpPr>
            <a:xfrm>
              <a:off x="4641548" y="2580978"/>
              <a:ext cx="293738" cy="1356996"/>
              <a:chOff x="5586164" y="3691489"/>
              <a:chExt cx="293738" cy="1356996"/>
            </a:xfrm>
          </p:grpSpPr>
          <p:cxnSp>
            <p:nvCxnSpPr>
              <p:cNvPr id="30" name="Straight Connector 29"/>
              <p:cNvCxnSpPr/>
              <p:nvPr/>
            </p:nvCxnSpPr>
            <p:spPr>
              <a:xfrm flipH="1">
                <a:off x="5586164" y="3691489"/>
                <a:ext cx="293738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/>
              <p:cNvCxnSpPr/>
              <p:nvPr/>
            </p:nvCxnSpPr>
            <p:spPr>
              <a:xfrm flipH="1">
                <a:off x="5586164" y="3992179"/>
                <a:ext cx="293738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Straight Connector 31"/>
              <p:cNvCxnSpPr/>
              <p:nvPr/>
            </p:nvCxnSpPr>
            <p:spPr>
              <a:xfrm flipH="1">
                <a:off x="5586164" y="4215769"/>
                <a:ext cx="293738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Straight Connector 32"/>
              <p:cNvCxnSpPr/>
              <p:nvPr/>
            </p:nvCxnSpPr>
            <p:spPr>
              <a:xfrm flipH="1">
                <a:off x="5586164" y="4632156"/>
                <a:ext cx="293738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Straight Connector 33"/>
              <p:cNvCxnSpPr/>
              <p:nvPr/>
            </p:nvCxnSpPr>
            <p:spPr>
              <a:xfrm flipH="1">
                <a:off x="5586164" y="5048485"/>
                <a:ext cx="293738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7" name="TextBox 26"/>
            <p:cNvSpPr txBox="1"/>
            <p:nvPr/>
          </p:nvSpPr>
          <p:spPr>
            <a:xfrm>
              <a:off x="4893034" y="3720643"/>
              <a:ext cx="418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10</a:t>
              </a:r>
              <a:endParaRPr lang="en-US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4893034" y="3296870"/>
              <a:ext cx="418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35</a:t>
              </a:r>
              <a:endParaRPr lang="en-US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4893034" y="2706758"/>
              <a:ext cx="418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50</a:t>
              </a:r>
              <a:endParaRPr lang="en-US" dirty="0"/>
            </a:p>
          </p:txBody>
        </p:sp>
      </p:grpSp>
      <p:grpSp>
        <p:nvGrpSpPr>
          <p:cNvPr id="49" name="Group 48"/>
          <p:cNvGrpSpPr/>
          <p:nvPr/>
        </p:nvGrpSpPr>
        <p:grpSpPr>
          <a:xfrm>
            <a:off x="5816975" y="2157157"/>
            <a:ext cx="6488194" cy="2665567"/>
            <a:chOff x="3291898" y="39533"/>
            <a:chExt cx="6488194" cy="2665567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" b="-62600"/>
            <a:stretch/>
          </p:blipFill>
          <p:spPr>
            <a:xfrm>
              <a:off x="4122738" y="795380"/>
              <a:ext cx="4571800" cy="1909720"/>
            </a:xfrm>
            <a:prstGeom prst="rect">
              <a:avLst/>
            </a:prstGeom>
          </p:spPr>
        </p:pic>
        <p:grpSp>
          <p:nvGrpSpPr>
            <p:cNvPr id="48" name="Group 47"/>
            <p:cNvGrpSpPr/>
            <p:nvPr/>
          </p:nvGrpSpPr>
          <p:grpSpPr>
            <a:xfrm>
              <a:off x="3291898" y="39533"/>
              <a:ext cx="6488194" cy="2091568"/>
              <a:chOff x="3291898" y="39533"/>
              <a:chExt cx="6488194" cy="2091568"/>
            </a:xfrm>
          </p:grpSpPr>
          <p:sp>
            <p:nvSpPr>
              <p:cNvPr id="5" name="TextBox 4"/>
              <p:cNvSpPr txBox="1"/>
              <p:nvPr/>
            </p:nvSpPr>
            <p:spPr>
              <a:xfrm>
                <a:off x="8694538" y="1662099"/>
                <a:ext cx="108555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/>
                  <a:t>WB: GAPDH</a:t>
                </a:r>
                <a:endParaRPr lang="en-US" sz="1400" b="1" dirty="0"/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 rot="18360394">
                <a:off x="4512782" y="299380"/>
                <a:ext cx="82747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/>
                  <a:t>Clone #1</a:t>
                </a:r>
                <a:endParaRPr lang="en-US" sz="1400" b="1" dirty="0"/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 rot="18360394">
                <a:off x="5038835" y="315590"/>
                <a:ext cx="78739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/>
                  <a:t>Clone#2</a:t>
                </a:r>
                <a:endParaRPr lang="en-US" sz="1400" b="1" dirty="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 rot="18360394">
                <a:off x="5544850" y="315590"/>
                <a:ext cx="78739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/>
                  <a:t>Clone#3</a:t>
                </a:r>
                <a:endParaRPr lang="en-US" sz="1400" b="1" dirty="0"/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 rot="18360394">
                <a:off x="6050865" y="315590"/>
                <a:ext cx="78739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/>
                  <a:t>Clone#4</a:t>
                </a:r>
                <a:endParaRPr lang="en-US" sz="1400" b="1" dirty="0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 rot="18360394">
                <a:off x="6556880" y="315590"/>
                <a:ext cx="78739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/>
                  <a:t>Clone#5</a:t>
                </a:r>
                <a:endParaRPr lang="en-US" sz="1400" b="1" dirty="0"/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 rot="18360394">
                <a:off x="7062895" y="315590"/>
                <a:ext cx="78739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/>
                  <a:t>Clone#6</a:t>
                </a:r>
                <a:endParaRPr lang="en-US" sz="1400" b="1" dirty="0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 rot="18360394">
                <a:off x="7568910" y="315590"/>
                <a:ext cx="78739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/>
                  <a:t>Clone#7</a:t>
                </a:r>
                <a:endParaRPr lang="en-US" sz="1400" b="1" dirty="0"/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 rot="18360394">
                <a:off x="8100896" y="336597"/>
                <a:ext cx="73545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/>
                  <a:t>Control</a:t>
                </a:r>
                <a:endParaRPr lang="en-US" sz="1400" b="1" dirty="0"/>
              </a:p>
            </p:txBody>
          </p:sp>
          <p:grpSp>
            <p:nvGrpSpPr>
              <p:cNvPr id="35" name="Group 34"/>
              <p:cNvGrpSpPr/>
              <p:nvPr/>
            </p:nvGrpSpPr>
            <p:grpSpPr>
              <a:xfrm flipH="1">
                <a:off x="3291898" y="778825"/>
                <a:ext cx="824948" cy="1352276"/>
                <a:chOff x="4641548" y="2285351"/>
                <a:chExt cx="670190" cy="1352276"/>
              </a:xfrm>
            </p:grpSpPr>
            <p:sp>
              <p:nvSpPr>
                <p:cNvPr id="36" name="TextBox 35"/>
                <p:cNvSpPr txBox="1"/>
                <p:nvPr/>
              </p:nvSpPr>
              <p:spPr>
                <a:xfrm>
                  <a:off x="4893034" y="2285351"/>
                  <a:ext cx="4187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 smtClean="0"/>
                    <a:t>70</a:t>
                  </a:r>
                  <a:endParaRPr lang="en-US" dirty="0"/>
                </a:p>
              </p:txBody>
            </p:sp>
            <p:sp>
              <p:nvSpPr>
                <p:cNvPr id="37" name="TextBox 36"/>
                <p:cNvSpPr txBox="1"/>
                <p:nvPr/>
              </p:nvSpPr>
              <p:spPr>
                <a:xfrm>
                  <a:off x="4893034" y="2934399"/>
                  <a:ext cx="4187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 smtClean="0"/>
                    <a:t>40</a:t>
                  </a:r>
                  <a:endParaRPr lang="en-US" dirty="0"/>
                </a:p>
              </p:txBody>
            </p:sp>
            <p:grpSp>
              <p:nvGrpSpPr>
                <p:cNvPr id="38" name="Group 37"/>
                <p:cNvGrpSpPr/>
                <p:nvPr/>
              </p:nvGrpSpPr>
              <p:grpSpPr>
                <a:xfrm>
                  <a:off x="4641548" y="2647653"/>
                  <a:ext cx="293738" cy="816842"/>
                  <a:chOff x="5586164" y="3758164"/>
                  <a:chExt cx="293738" cy="816842"/>
                </a:xfrm>
              </p:grpSpPr>
              <p:cxnSp>
                <p:nvCxnSpPr>
                  <p:cNvPr id="42" name="Straight Connector 41"/>
                  <p:cNvCxnSpPr/>
                  <p:nvPr/>
                </p:nvCxnSpPr>
                <p:spPr>
                  <a:xfrm flipH="1">
                    <a:off x="5586164" y="3758164"/>
                    <a:ext cx="293738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3" name="Straight Connector 42"/>
                  <p:cNvCxnSpPr/>
                  <p:nvPr/>
                </p:nvCxnSpPr>
                <p:spPr>
                  <a:xfrm flipH="1">
                    <a:off x="5586164" y="4030279"/>
                    <a:ext cx="293738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4" name="Straight Connector 43"/>
                  <p:cNvCxnSpPr/>
                  <p:nvPr/>
                </p:nvCxnSpPr>
                <p:spPr>
                  <a:xfrm flipH="1">
                    <a:off x="5586164" y="4320544"/>
                    <a:ext cx="293738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5" name="Straight Connector 44"/>
                  <p:cNvCxnSpPr/>
                  <p:nvPr/>
                </p:nvCxnSpPr>
                <p:spPr>
                  <a:xfrm flipH="1">
                    <a:off x="5586164" y="4575006"/>
                    <a:ext cx="293738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40" name="TextBox 39"/>
                <p:cNvSpPr txBox="1"/>
                <p:nvPr/>
              </p:nvSpPr>
              <p:spPr>
                <a:xfrm>
                  <a:off x="4893034" y="3268295"/>
                  <a:ext cx="4187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 smtClean="0"/>
                    <a:t>35</a:t>
                  </a:r>
                  <a:endParaRPr lang="en-US" dirty="0"/>
                </a:p>
              </p:txBody>
            </p:sp>
            <p:sp>
              <p:nvSpPr>
                <p:cNvPr id="41" name="TextBox 40"/>
                <p:cNvSpPr txBox="1"/>
                <p:nvPr/>
              </p:nvSpPr>
              <p:spPr>
                <a:xfrm>
                  <a:off x="4893034" y="2706758"/>
                  <a:ext cx="41870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 smtClean="0"/>
                    <a:t>50</a:t>
                  </a:r>
                  <a:endParaRPr lang="en-US" dirty="0"/>
                </a:p>
              </p:txBody>
            </p:sp>
          </p:grpSp>
        </p:grpSp>
      </p:grpSp>
      <p:sp>
        <p:nvSpPr>
          <p:cNvPr id="51" name="TextBox 50"/>
          <p:cNvSpPr txBox="1"/>
          <p:nvPr/>
        </p:nvSpPr>
        <p:spPr>
          <a:xfrm>
            <a:off x="0" y="130406"/>
            <a:ext cx="12192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 smtClean="0"/>
              <a:t>Unaltered Blot for TSG101 Knock Down in CM61 cell lines</a:t>
            </a:r>
            <a:endParaRPr 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42216307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216131"/>
            <a:ext cx="12192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 smtClean="0"/>
              <a:t>Western Blot Analysis of </a:t>
            </a:r>
            <a:r>
              <a:rPr lang="en-US" sz="2400" b="1" dirty="0" err="1" smtClean="0"/>
              <a:t>PhosphoMAPK</a:t>
            </a:r>
            <a:r>
              <a:rPr lang="en-US" sz="2400" b="1" dirty="0" smtClean="0"/>
              <a:t> Array for CM61 cell line Extract</a:t>
            </a:r>
            <a:endParaRPr lang="en-US" sz="2400" b="1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4" t="32993" r="87654" b="28831"/>
          <a:stretch/>
        </p:blipFill>
        <p:spPr>
          <a:xfrm rot="16200000">
            <a:off x="2436424" y="162613"/>
            <a:ext cx="2057400" cy="5948574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3"/>
          <a:srcRect l="69791" t="38148" r="12813" b="38149"/>
          <a:stretch/>
        </p:blipFill>
        <p:spPr>
          <a:xfrm>
            <a:off x="228600" y="4400772"/>
            <a:ext cx="6362700" cy="2438400"/>
          </a:xfrm>
          <a:prstGeom prst="rect">
            <a:avLst/>
          </a:prstGeom>
        </p:spPr>
      </p:pic>
      <p:sp>
        <p:nvSpPr>
          <p:cNvPr id="17" name="Rectangle 16"/>
          <p:cNvSpPr/>
          <p:nvPr/>
        </p:nvSpPr>
        <p:spPr>
          <a:xfrm>
            <a:off x="3752850" y="2871788"/>
            <a:ext cx="497681" cy="3381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4272106" y="2874170"/>
            <a:ext cx="497681" cy="3381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/>
          <p:cNvSpPr/>
          <p:nvPr/>
        </p:nvSpPr>
        <p:spPr>
          <a:xfrm>
            <a:off x="1209184" y="2814905"/>
            <a:ext cx="497681" cy="3381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/>
          <p:cNvSpPr txBox="1"/>
          <p:nvPr/>
        </p:nvSpPr>
        <p:spPr>
          <a:xfrm>
            <a:off x="8688102" y="2055914"/>
            <a:ext cx="2149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3, B4: pAKT1 (S473)</a:t>
            </a: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43" t="57147" r="91762" b="39602"/>
          <a:stretch/>
        </p:blipFill>
        <p:spPr>
          <a:xfrm rot="16200000">
            <a:off x="7424114" y="4090364"/>
            <a:ext cx="997635" cy="1530340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84" t="37863" r="91311" b="59049"/>
          <a:stretch/>
        </p:blipFill>
        <p:spPr>
          <a:xfrm rot="16200000">
            <a:off x="7427554" y="1063084"/>
            <a:ext cx="1000034" cy="1539624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05" t="53654" r="92833" b="43075"/>
          <a:stretch/>
        </p:blipFill>
        <p:spPr>
          <a:xfrm rot="16200000">
            <a:off x="7417012" y="2566565"/>
            <a:ext cx="1021121" cy="1539621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8688102" y="3520275"/>
            <a:ext cx="28825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13,B14: pERK1 (T202/Y204)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8697383" y="5022040"/>
            <a:ext cx="28825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15,B16: pERK2 (T185/Y187)</a:t>
            </a:r>
          </a:p>
        </p:txBody>
      </p:sp>
      <p:sp>
        <p:nvSpPr>
          <p:cNvPr id="23" name="Rectangle 22"/>
          <p:cNvSpPr/>
          <p:nvPr/>
        </p:nvSpPr>
        <p:spPr>
          <a:xfrm>
            <a:off x="7157759" y="1317957"/>
            <a:ext cx="1530343" cy="101255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7157759" y="2834379"/>
            <a:ext cx="1530343" cy="101255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7157759" y="4361287"/>
            <a:ext cx="1530343" cy="101255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7168893" y="2295310"/>
            <a:ext cx="160172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/>
              <a:t>28723.321: 26364.472</a:t>
            </a:r>
          </a:p>
        </p:txBody>
      </p:sp>
      <p:sp>
        <p:nvSpPr>
          <p:cNvPr id="29" name="Rectangle 28"/>
          <p:cNvSpPr/>
          <p:nvPr/>
        </p:nvSpPr>
        <p:spPr>
          <a:xfrm>
            <a:off x="7157759" y="3878007"/>
            <a:ext cx="159530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/>
              <a:t>27157.200: 35376.241</a:t>
            </a:r>
          </a:p>
        </p:txBody>
      </p:sp>
      <p:sp>
        <p:nvSpPr>
          <p:cNvPr id="30" name="Rectangle 29"/>
          <p:cNvSpPr/>
          <p:nvPr/>
        </p:nvSpPr>
        <p:spPr>
          <a:xfrm>
            <a:off x="7168893" y="5354352"/>
            <a:ext cx="160172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/>
              <a:t>55659.492: 58276.090</a:t>
            </a:r>
          </a:p>
        </p:txBody>
      </p:sp>
    </p:spTree>
    <p:extLst>
      <p:ext uri="{BB962C8B-B14F-4D97-AF65-F5344CB8AC3E}">
        <p14:creationId xmlns:p14="http://schemas.microsoft.com/office/powerpoint/2010/main" val="2731878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216131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Human Phospho-MAPK Array Coordinates (R&amp;D Catalog#ARY002B)</a:t>
            </a:r>
            <a:endParaRPr lang="en-US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/>
          <a:srcRect l="69382" t="24408" r="12341" b="9068"/>
          <a:stretch/>
        </p:blipFill>
        <p:spPr>
          <a:xfrm>
            <a:off x="3167157" y="585463"/>
            <a:ext cx="5857685" cy="59963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7301730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216131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Western Blot Analysis of Phosphokinase Array for CM61 cell line Extract</a:t>
            </a:r>
            <a:endParaRPr lang="en-US" dirty="0"/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502" t="4243" r="66566" b="81270"/>
          <a:stretch/>
        </p:blipFill>
        <p:spPr>
          <a:xfrm rot="10800000">
            <a:off x="4250531" y="1480008"/>
            <a:ext cx="2438400" cy="2771481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4"/>
          <a:srcRect l="72292" t="52222" r="15417" b="24629"/>
          <a:stretch/>
        </p:blipFill>
        <p:spPr>
          <a:xfrm>
            <a:off x="895350" y="4476750"/>
            <a:ext cx="4495800" cy="238125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2080" t="6688" r="7571" b="78745"/>
          <a:stretch/>
        </p:blipFill>
        <p:spPr>
          <a:xfrm rot="10800000">
            <a:off x="1066799" y="1477677"/>
            <a:ext cx="3114389" cy="2786813"/>
          </a:xfrm>
          <a:prstGeom prst="rect">
            <a:avLst/>
          </a:prstGeom>
        </p:spPr>
      </p:pic>
      <p:sp>
        <p:nvSpPr>
          <p:cNvPr id="20" name="Rectangle 19"/>
          <p:cNvSpPr/>
          <p:nvPr/>
        </p:nvSpPr>
        <p:spPr>
          <a:xfrm>
            <a:off x="3611656" y="2192969"/>
            <a:ext cx="497681" cy="3381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4373978" y="2192969"/>
            <a:ext cx="497681" cy="3381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/>
          <p:cNvSpPr txBox="1"/>
          <p:nvPr/>
        </p:nvSpPr>
        <p:spPr>
          <a:xfrm>
            <a:off x="8571037" y="2929643"/>
            <a:ext cx="28841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-B9, B10: pAKT1/2/3 (S473)</a:t>
            </a:r>
          </a:p>
        </p:txBody>
      </p:sp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544" t="13156" r="67696" b="85405"/>
          <a:stretch/>
        </p:blipFill>
        <p:spPr>
          <a:xfrm rot="10800000">
            <a:off x="7075496" y="3611138"/>
            <a:ext cx="1516054" cy="1041608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2688" t="15727" r="24181" b="82631"/>
          <a:stretch/>
        </p:blipFill>
        <p:spPr>
          <a:xfrm rot="10800000">
            <a:off x="7075496" y="2232370"/>
            <a:ext cx="1535104" cy="1007295"/>
          </a:xfrm>
          <a:prstGeom prst="rect">
            <a:avLst/>
          </a:prstGeom>
        </p:spPr>
      </p:pic>
      <p:sp>
        <p:nvSpPr>
          <p:cNvPr id="24" name="Rectangle 23"/>
          <p:cNvSpPr/>
          <p:nvPr/>
        </p:nvSpPr>
        <p:spPr>
          <a:xfrm>
            <a:off x="7080257" y="2239621"/>
            <a:ext cx="1530343" cy="101255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7080257" y="3640189"/>
            <a:ext cx="1530343" cy="101255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TextBox 25"/>
          <p:cNvSpPr txBox="1"/>
          <p:nvPr/>
        </p:nvSpPr>
        <p:spPr>
          <a:xfrm>
            <a:off x="8577995" y="4320927"/>
            <a:ext cx="29097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-B11, B12: pAKT1/23 (T308)</a:t>
            </a:r>
            <a:endParaRPr lang="en-US" dirty="0"/>
          </a:p>
        </p:txBody>
      </p:sp>
      <p:sp>
        <p:nvSpPr>
          <p:cNvPr id="4" name="Rectangle 3"/>
          <p:cNvSpPr/>
          <p:nvPr/>
        </p:nvSpPr>
        <p:spPr>
          <a:xfrm>
            <a:off x="7075496" y="3255797"/>
            <a:ext cx="15664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/>
              <a:t>28488.744:28009.765</a:t>
            </a:r>
            <a:endParaRPr lang="en-US" b="1" dirty="0" smtClean="0"/>
          </a:p>
        </p:txBody>
      </p:sp>
      <p:sp>
        <p:nvSpPr>
          <p:cNvPr id="6" name="Rectangle 5"/>
          <p:cNvSpPr/>
          <p:nvPr/>
        </p:nvSpPr>
        <p:spPr>
          <a:xfrm>
            <a:off x="7037397" y="4690259"/>
            <a:ext cx="165892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38916.442: 36336.099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152764719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216131"/>
            <a:ext cx="12192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 smtClean="0"/>
              <a:t>Human Phosphokinase Array Coordinates (R&amp;D Catalog#ARY003B)</a:t>
            </a:r>
            <a:endParaRPr lang="en-US" sz="2400" b="1" dirty="0"/>
          </a:p>
        </p:txBody>
      </p:sp>
      <p:grpSp>
        <p:nvGrpSpPr>
          <p:cNvPr id="4" name="Group 3"/>
          <p:cNvGrpSpPr/>
          <p:nvPr/>
        </p:nvGrpSpPr>
        <p:grpSpPr>
          <a:xfrm>
            <a:off x="1257300" y="742950"/>
            <a:ext cx="10326098" cy="5448300"/>
            <a:chOff x="1295400" y="742950"/>
            <a:chExt cx="10326098" cy="54483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68958" t="16667" r="11979" b="12592"/>
            <a:stretch/>
          </p:blipFill>
          <p:spPr>
            <a:xfrm>
              <a:off x="1295400" y="742950"/>
              <a:ext cx="5220099" cy="5448300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3"/>
            <a:srcRect l="69271" t="18519" r="12083" b="31111"/>
            <a:stretch/>
          </p:blipFill>
          <p:spPr>
            <a:xfrm>
              <a:off x="6515499" y="1527391"/>
              <a:ext cx="5105999" cy="387941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10944182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0" y="216131"/>
            <a:ext cx="12192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 smtClean="0"/>
              <a:t>Unaltered Western Blot for </a:t>
            </a:r>
            <a:r>
              <a:rPr lang="en-US" sz="2400" b="1" dirty="0" err="1" smtClean="0"/>
              <a:t>for</a:t>
            </a:r>
            <a:r>
              <a:rPr lang="en-US" sz="2400" b="1" dirty="0" smtClean="0"/>
              <a:t> All CTC cell lines</a:t>
            </a:r>
            <a:endParaRPr lang="en-US" sz="2400" b="1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158" r="87927" b="28227"/>
          <a:stretch/>
        </p:blipFill>
        <p:spPr>
          <a:xfrm rot="16200000">
            <a:off x="2146128" y="311318"/>
            <a:ext cx="1323976" cy="338738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5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615" t="4786" r="6923" b="80515"/>
          <a:stretch/>
        </p:blipFill>
        <p:spPr>
          <a:xfrm rot="10800000">
            <a:off x="1114423" y="4095749"/>
            <a:ext cx="5998151" cy="1404524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038223" y="905622"/>
            <a:ext cx="3842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Phospho MAPK array CM61 Cell lysate</a:t>
            </a:r>
            <a:endParaRPr lang="en-US" b="1" dirty="0"/>
          </a:p>
        </p:txBody>
      </p:sp>
      <p:sp>
        <p:nvSpPr>
          <p:cNvPr id="9" name="TextBox 8"/>
          <p:cNvSpPr txBox="1"/>
          <p:nvPr/>
        </p:nvSpPr>
        <p:spPr>
          <a:xfrm>
            <a:off x="1038223" y="3282434"/>
            <a:ext cx="38152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Phosphokinase array CM61 Cell lysate</a:t>
            </a:r>
            <a:endParaRPr lang="en-US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1257298" y="3787972"/>
            <a:ext cx="50113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Blot A                                                                                                   Blot B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3864439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75</TotalTime>
  <Words>625</Words>
  <Application>Microsoft Office PowerPoint</Application>
  <PresentationFormat>Widescreen</PresentationFormat>
  <Paragraphs>152</Paragraphs>
  <Slides>1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1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Miam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rles Jacob, Harrys Kishore</dc:creator>
  <cp:lastModifiedBy>Charles Jacob, Harrys Kishore</cp:lastModifiedBy>
  <cp:revision>87</cp:revision>
  <dcterms:created xsi:type="dcterms:W3CDTF">2021-04-14T23:47:54Z</dcterms:created>
  <dcterms:modified xsi:type="dcterms:W3CDTF">2021-05-14T01:40:05Z</dcterms:modified>
</cp:coreProperties>
</file>